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98703EE-11E6-6C4C-9F18-D6A7F677B704}" v="49" dt="2021-05-09T16:18:36.12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47"/>
    <p:restoredTop sz="94720"/>
  </p:normalViewPr>
  <p:slideViewPr>
    <p:cSldViewPr snapToGrid="0">
      <p:cViewPr>
        <p:scale>
          <a:sx n="268" d="100"/>
          <a:sy n="268" d="100"/>
        </p:scale>
        <p:origin x="2256" y="-58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u, Dihan" userId="5577ebe6-3386-48d4-b782-5fb52b4e7fc6" providerId="ADAL" clId="{4850DFDE-C21A-FB4E-8864-BACBDBBCA548}"/>
    <pc:docChg chg="undo custSel addSld modSld">
      <pc:chgData name="Zhu, Dihan" userId="5577ebe6-3386-48d4-b782-5fb52b4e7fc6" providerId="ADAL" clId="{4850DFDE-C21A-FB4E-8864-BACBDBBCA548}" dt="2021-03-15T19:01:45.057" v="1439" actId="1076"/>
      <pc:docMkLst>
        <pc:docMk/>
      </pc:docMkLst>
      <pc:sldChg chg="addSp delSp modSp mod">
        <pc:chgData name="Zhu, Dihan" userId="5577ebe6-3386-48d4-b782-5fb52b4e7fc6" providerId="ADAL" clId="{4850DFDE-C21A-FB4E-8864-BACBDBBCA548}" dt="2021-03-15T19:01:45.057" v="1439" actId="1076"/>
        <pc:sldMkLst>
          <pc:docMk/>
          <pc:sldMk cId="2019332721" sldId="258"/>
        </pc:sldMkLst>
        <pc:spChg chg="mod">
          <ac:chgData name="Zhu, Dihan" userId="5577ebe6-3386-48d4-b782-5fb52b4e7fc6" providerId="ADAL" clId="{4850DFDE-C21A-FB4E-8864-BACBDBBCA548}" dt="2021-03-15T19:01:45.057" v="1439" actId="1076"/>
          <ac:spMkLst>
            <pc:docMk/>
            <pc:sldMk cId="2019332721" sldId="258"/>
            <ac:spMk id="4" creationId="{4DCE3546-07F4-4B5F-8F06-336B04FD8428}"/>
          </ac:spMkLst>
        </pc:spChg>
        <pc:spChg chg="mod">
          <ac:chgData name="Zhu, Dihan" userId="5577ebe6-3386-48d4-b782-5fb52b4e7fc6" providerId="ADAL" clId="{4850DFDE-C21A-FB4E-8864-BACBDBBCA548}" dt="2021-03-15T19:01:28.656" v="1415" actId="1037"/>
          <ac:spMkLst>
            <pc:docMk/>
            <pc:sldMk cId="2019332721" sldId="258"/>
            <ac:spMk id="5" creationId="{7B49AA66-C0DF-4D2E-A9D2-FEC586E51039}"/>
          </ac:spMkLst>
        </pc:spChg>
        <pc:spChg chg="mod">
          <ac:chgData name="Zhu, Dihan" userId="5577ebe6-3386-48d4-b782-5fb52b4e7fc6" providerId="ADAL" clId="{4850DFDE-C21A-FB4E-8864-BACBDBBCA548}" dt="2021-03-15T19:01:35.303" v="1426" actId="1037"/>
          <ac:spMkLst>
            <pc:docMk/>
            <pc:sldMk cId="2019332721" sldId="258"/>
            <ac:spMk id="8" creationId="{EEFBA53D-17C2-4685-8514-838EE362668C}"/>
          </ac:spMkLst>
        </pc:spChg>
        <pc:spChg chg="mod">
          <ac:chgData name="Zhu, Dihan" userId="5577ebe6-3386-48d4-b782-5fb52b4e7fc6" providerId="ADAL" clId="{4850DFDE-C21A-FB4E-8864-BACBDBBCA548}" dt="2021-03-15T19:01:39.772" v="1438" actId="1037"/>
          <ac:spMkLst>
            <pc:docMk/>
            <pc:sldMk cId="2019332721" sldId="258"/>
            <ac:spMk id="9" creationId="{00B09761-C341-4C1F-AB66-99DFE798928A}"/>
          </ac:spMkLst>
        </pc:spChg>
        <pc:picChg chg="del mod">
          <ac:chgData name="Zhu, Dihan" userId="5577ebe6-3386-48d4-b782-5fb52b4e7fc6" providerId="ADAL" clId="{4850DFDE-C21A-FB4E-8864-BACBDBBCA548}" dt="2021-03-15T17:57:01.595" v="812" actId="478"/>
          <ac:picMkLst>
            <pc:docMk/>
            <pc:sldMk cId="2019332721" sldId="258"/>
            <ac:picMk id="2" creationId="{C64840E9-62A3-440F-866E-9E074DBA6D3F}"/>
          </ac:picMkLst>
        </pc:picChg>
        <pc:picChg chg="add mod">
          <ac:chgData name="Zhu, Dihan" userId="5577ebe6-3386-48d4-b782-5fb52b4e7fc6" providerId="ADAL" clId="{4850DFDE-C21A-FB4E-8864-BACBDBBCA548}" dt="2021-03-15T19:01:07.923" v="1401" actId="14100"/>
          <ac:picMkLst>
            <pc:docMk/>
            <pc:sldMk cId="2019332721" sldId="258"/>
            <ac:picMk id="13" creationId="{21EF0E44-30FF-D146-8F24-2AFF252A61EC}"/>
          </ac:picMkLst>
        </pc:picChg>
        <pc:cxnChg chg="mod">
          <ac:chgData name="Zhu, Dihan" userId="5577ebe6-3386-48d4-b782-5fb52b4e7fc6" providerId="ADAL" clId="{4850DFDE-C21A-FB4E-8864-BACBDBBCA548}" dt="2021-03-15T19:01:24.589" v="1406" actId="14100"/>
          <ac:cxnSpMkLst>
            <pc:docMk/>
            <pc:sldMk cId="2019332721" sldId="258"/>
            <ac:cxnSpMk id="10" creationId="{193366E6-9FF2-437A-9BB0-BFB3339C5F78}"/>
          </ac:cxnSpMkLst>
        </pc:cxnChg>
      </pc:sldChg>
      <pc:sldChg chg="addSp delSp modSp mod">
        <pc:chgData name="Zhu, Dihan" userId="5577ebe6-3386-48d4-b782-5fb52b4e7fc6" providerId="ADAL" clId="{4850DFDE-C21A-FB4E-8864-BACBDBBCA548}" dt="2021-03-15T18:52:14.689" v="1400" actId="1036"/>
        <pc:sldMkLst>
          <pc:docMk/>
          <pc:sldMk cId="922933440" sldId="259"/>
        </pc:sldMkLst>
        <pc:spChg chg="add mod">
          <ac:chgData name="Zhu, Dihan" userId="5577ebe6-3386-48d4-b782-5fb52b4e7fc6" providerId="ADAL" clId="{4850DFDE-C21A-FB4E-8864-BACBDBBCA548}" dt="2021-03-15T18:51:39.836" v="1390" actId="403"/>
          <ac:spMkLst>
            <pc:docMk/>
            <pc:sldMk cId="922933440" sldId="259"/>
            <ac:spMk id="27" creationId="{EC1E1C10-E9F1-7341-BB46-890821FE3701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28" creationId="{28BFDF4D-F3D6-BA48-A108-685EAB1FFCD1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29" creationId="{C323FE99-9D25-7C4B-BC13-C3901861EE06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30" creationId="{6570C6C5-6AA2-ED4B-9E69-373834C25E1A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31" creationId="{1AE7C739-21E1-6C4A-BBD9-B044B8B7E5C2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33" creationId="{799ECF55-5FB3-B044-B007-A4EA205E8887}"/>
          </ac:spMkLst>
        </pc:spChg>
        <pc:spChg chg="add del mod">
          <ac:chgData name="Zhu, Dihan" userId="5577ebe6-3386-48d4-b782-5fb52b4e7fc6" providerId="ADAL" clId="{4850DFDE-C21A-FB4E-8864-BACBDBBCA548}" dt="2021-03-15T15:54:43.551" v="688" actId="478"/>
          <ac:spMkLst>
            <pc:docMk/>
            <pc:sldMk cId="922933440" sldId="259"/>
            <ac:spMk id="34" creationId="{EBD45141-A7EB-D641-8DE1-FD0486E8742A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38" creationId="{6083B641-A0B2-7546-A65C-D7AB6D6A4C8B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41" creationId="{EA179667-C4A4-624F-A833-C6724A476ECD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42" creationId="{0A2F2D9C-06CD-054B-A059-373B545C4B2B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43" creationId="{C084A750-A577-B745-9BAD-D241593BA30B}"/>
          </ac:spMkLst>
        </pc:spChg>
        <pc:spChg chg="add del mod">
          <ac:chgData name="Zhu, Dihan" userId="5577ebe6-3386-48d4-b782-5fb52b4e7fc6" providerId="ADAL" clId="{4850DFDE-C21A-FB4E-8864-BACBDBBCA548}" dt="2021-03-15T15:57:58.902" v="765"/>
          <ac:spMkLst>
            <pc:docMk/>
            <pc:sldMk cId="922933440" sldId="259"/>
            <ac:spMk id="44" creationId="{B06EBB15-CB5F-C14A-94EB-6D739ADD376A}"/>
          </ac:spMkLst>
        </pc:spChg>
        <pc:spChg chg="add del mod">
          <ac:chgData name="Zhu, Dihan" userId="5577ebe6-3386-48d4-b782-5fb52b4e7fc6" providerId="ADAL" clId="{4850DFDE-C21A-FB4E-8864-BACBDBBCA548}" dt="2021-03-15T15:57:58.902" v="765"/>
          <ac:spMkLst>
            <pc:docMk/>
            <pc:sldMk cId="922933440" sldId="259"/>
            <ac:spMk id="45" creationId="{7C614643-2654-1946-9434-3360C3CA0132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46" creationId="{0EEAFBEE-F23E-014F-9098-64C8D5E78A7C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47" creationId="{22FBF720-71DA-4B4D-94D7-5A619479A8AB}"/>
          </ac:spMkLst>
        </pc:spChg>
        <pc:spChg chg="add mod">
          <ac:chgData name="Zhu, Dihan" userId="5577ebe6-3386-48d4-b782-5fb52b4e7fc6" providerId="ADAL" clId="{4850DFDE-C21A-FB4E-8864-BACBDBBCA548}" dt="2021-03-15T18:48:18.417" v="1267" actId="1076"/>
          <ac:spMkLst>
            <pc:docMk/>
            <pc:sldMk cId="922933440" sldId="259"/>
            <ac:spMk id="48" creationId="{6EBA3E53-F2FD-8F4B-967E-621B61BE624E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49" creationId="{44953206-215D-3449-A528-1A77403FF871}"/>
          </ac:spMkLst>
        </pc:spChg>
        <pc:spChg chg="add mod">
          <ac:chgData name="Zhu, Dihan" userId="5577ebe6-3386-48d4-b782-5fb52b4e7fc6" providerId="ADAL" clId="{4850DFDE-C21A-FB4E-8864-BACBDBBCA548}" dt="2021-03-15T18:48:18.417" v="1267" actId="1076"/>
          <ac:spMkLst>
            <pc:docMk/>
            <pc:sldMk cId="922933440" sldId="259"/>
            <ac:spMk id="50" creationId="{9D16045E-09CD-434D-A422-826260D26C6D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51" creationId="{072FDE99-F3ED-A344-9AF3-BA82438B18DE}"/>
          </ac:spMkLst>
        </pc:spChg>
        <pc:spChg chg="add mod">
          <ac:chgData name="Zhu, Dihan" userId="5577ebe6-3386-48d4-b782-5fb52b4e7fc6" providerId="ADAL" clId="{4850DFDE-C21A-FB4E-8864-BACBDBBCA548}" dt="2021-03-15T18:48:18.417" v="1267" actId="1076"/>
          <ac:spMkLst>
            <pc:docMk/>
            <pc:sldMk cId="922933440" sldId="259"/>
            <ac:spMk id="52" creationId="{AD7928A7-1951-8647-9A0F-F7C7E8A678F9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53" creationId="{10462C25-4C71-2547-9075-6E0BA4DDD37A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54" creationId="{8D8DBEB3-DA39-B144-BF8B-F6D20CF43C33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55" creationId="{9D67D62D-E3D0-B24E-9E0D-14B73DAD4C26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56" creationId="{A7D63779-DB42-E349-B366-90AE744584F8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57" creationId="{5D3936F5-35B2-3846-A1C4-B4774EAE5095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58" creationId="{E916E6CE-8BEA-F543-BC08-C363DAF6E916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59" creationId="{1A84BAAD-497E-E644-B10B-A62515B94176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0" creationId="{A85DE04C-1F5D-1449-BDE1-A70193FBF334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1" creationId="{103B6D22-93B2-374D-8D1A-BA438A1E4460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2" creationId="{B3CCA805-6EDF-5140-97B0-332FF1B9C699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3" creationId="{FC83751E-32AB-284F-A603-A51AEF8F91AE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4" creationId="{E1789325-E283-9C49-89BE-AB78345C0735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5" creationId="{3D673A5D-1A5D-0D43-AA6B-5F82D5CA461E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6" creationId="{4D7E9460-1430-D441-BFDD-93D7B6B74D48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69" creationId="{A47B43F1-42B1-E34B-B2FE-35625BA0BD6B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0" creationId="{3169BB54-0EA9-384F-AE0A-34EC9F3073A3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1" creationId="{518A9013-8EF9-4F42-BA55-8606F31F3A9E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2" creationId="{D81F4253-D750-4141-B827-FF3878AC4FD4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3" creationId="{C02ADB1B-8A10-1449-90BB-AEC56844DA6D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4" creationId="{D7742FD2-3A21-1544-9E18-0A3F9D7758F2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5" creationId="{ECF30C14-B295-4948-A0AC-0B54FAE94E4D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6" creationId="{E1AF4BA5-803C-6349-BDC1-D67B0402950C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77" creationId="{39C27199-1E0C-5C4B-B4EE-C56ED2A569A2}"/>
          </ac:spMkLst>
        </pc:spChg>
        <pc:spChg chg="add mod">
          <ac:chgData name="Zhu, Dihan" userId="5577ebe6-3386-48d4-b782-5fb52b4e7fc6" providerId="ADAL" clId="{4850DFDE-C21A-FB4E-8864-BACBDBBCA548}" dt="2021-03-15T18:51:39.836" v="1390" actId="403"/>
          <ac:spMkLst>
            <pc:docMk/>
            <pc:sldMk cId="922933440" sldId="259"/>
            <ac:spMk id="81" creationId="{B2C68F28-0CA3-6E4C-87E0-7681C0D79748}"/>
          </ac:spMkLst>
        </pc:spChg>
        <pc:spChg chg="add mod">
          <ac:chgData name="Zhu, Dihan" userId="5577ebe6-3386-48d4-b782-5fb52b4e7fc6" providerId="ADAL" clId="{4850DFDE-C21A-FB4E-8864-BACBDBBCA548}" dt="2021-03-15T18:51:39.836" v="1390" actId="403"/>
          <ac:spMkLst>
            <pc:docMk/>
            <pc:sldMk cId="922933440" sldId="259"/>
            <ac:spMk id="82" creationId="{0BFAE917-2394-B245-9385-3BFE153A6E15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3" creationId="{E171F799-A1C1-894C-AA3E-BFD49E1A2EE4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4" creationId="{E82FB918-26C9-6747-8820-056146A082A1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5" creationId="{9F184D3B-62AF-254C-8571-D3104BDFACE7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6" creationId="{C0BE20EC-182B-F648-AABC-E1B8940600A5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7" creationId="{04C6965C-853F-AB4E-9058-F986202D5A5A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8" creationId="{EF3F814F-6222-5D44-BE29-CD4B2BE0C102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89" creationId="{C1F2AC1F-F40C-2C42-90D6-71406748A4B7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90" creationId="{F182028A-CA6C-724A-84CF-E33EEA4AEA28}"/>
          </ac:spMkLst>
        </pc:spChg>
        <pc:spChg chg="add del mod">
          <ac:chgData name="Zhu, Dihan" userId="5577ebe6-3386-48d4-b782-5fb52b4e7fc6" providerId="ADAL" clId="{4850DFDE-C21A-FB4E-8864-BACBDBBCA548}" dt="2021-03-15T18:23:14.064" v="916" actId="478"/>
          <ac:spMkLst>
            <pc:docMk/>
            <pc:sldMk cId="922933440" sldId="259"/>
            <ac:spMk id="91" creationId="{72FBFC6C-EC64-3E47-B827-075E91500C5E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2" creationId="{B843E710-9C83-C14A-89C4-81009839C941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3" creationId="{9B7C7C10-AC00-AE4D-B16C-5456DE6059FD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4" creationId="{6D895B5D-3444-F44F-96EA-2DF8E4B26B52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5" creationId="{13D889E7-C072-D84C-A437-D87B6D299BDE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6" creationId="{00F926C5-8A0F-4D44-BE99-8556AE111BD7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7" creationId="{9747AD08-A6BC-DD4E-A2D6-3E1488B707E4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98" creationId="{BA724570-B338-4C41-885F-0C058467CBF8}"/>
          </ac:spMkLst>
        </pc:spChg>
        <pc:spChg chg="add del mod">
          <ac:chgData name="Zhu, Dihan" userId="5577ebe6-3386-48d4-b782-5fb52b4e7fc6" providerId="ADAL" clId="{4850DFDE-C21A-FB4E-8864-BACBDBBCA548}" dt="2021-03-15T18:29:53.415" v="1138"/>
          <ac:spMkLst>
            <pc:docMk/>
            <pc:sldMk cId="922933440" sldId="259"/>
            <ac:spMk id="99" creationId="{9E11D499-F25C-B646-9B0B-9EEE10684D50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0" creationId="{DE496E81-E8C7-FA4C-BC5A-78AB166EA334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1" creationId="{98AA2353-2F7C-924D-99C0-1C8AEDAF3403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2" creationId="{D00920BC-290F-1E44-91CD-A6E7B331D811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3" creationId="{179A1A34-3B56-024E-8BA7-7C74DA859012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4" creationId="{81048A64-D87C-E842-BE50-A6FEB53ADE69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5" creationId="{7CDCB68B-BAF2-4A4C-A91C-503C5938B04C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6" creationId="{3D018C4A-537E-944C-BB66-7A32A3FA37C1}"/>
          </ac:spMkLst>
        </pc:spChg>
        <pc:spChg chg="add del mod">
          <ac:chgData name="Zhu, Dihan" userId="5577ebe6-3386-48d4-b782-5fb52b4e7fc6" providerId="ADAL" clId="{4850DFDE-C21A-FB4E-8864-BACBDBBCA548}" dt="2021-03-15T18:31:40.740" v="1145"/>
          <ac:spMkLst>
            <pc:docMk/>
            <pc:sldMk cId="922933440" sldId="259"/>
            <ac:spMk id="107" creationId="{EF117EE8-75A7-4448-90C9-75431F7FEE1E}"/>
          </ac:spMkLst>
        </pc:spChg>
        <pc:spChg chg="add del mod">
          <ac:chgData name="Zhu, Dihan" userId="5577ebe6-3386-48d4-b782-5fb52b4e7fc6" providerId="ADAL" clId="{4850DFDE-C21A-FB4E-8864-BACBDBBCA548}" dt="2021-03-15T18:48:56.629" v="1272" actId="21"/>
          <ac:spMkLst>
            <pc:docMk/>
            <pc:sldMk cId="922933440" sldId="259"/>
            <ac:spMk id="108" creationId="{78BA7A28-4181-A148-B31A-F5395DED8220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1" creationId="{162EADAF-8F79-FA47-BB46-D7AD5F5722C2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2" creationId="{FB1914CF-D14E-234C-99FC-A41A8C8461E9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3" creationId="{E1249EA3-0035-A24D-9997-63CFD22AFA6A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4" creationId="{5378A907-187E-E64E-93E9-F235ED1F2956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5" creationId="{F6B8D4DC-BFB8-E84C-B962-D5F4A5306801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6" creationId="{4825C053-B2A5-9649-AF0E-393A5B07F289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7" creationId="{83F21031-B493-AE44-81C2-278B4DD0CBB4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8" creationId="{5B66DB07-6332-AF4F-A380-D77930E8795A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19" creationId="{7004549A-37E6-894F-9954-CDF41F389789}"/>
          </ac:spMkLst>
        </pc:spChg>
        <pc:spChg chg="add mod">
          <ac:chgData name="Zhu, Dihan" userId="5577ebe6-3386-48d4-b782-5fb52b4e7fc6" providerId="ADAL" clId="{4850DFDE-C21A-FB4E-8864-BACBDBBCA548}" dt="2021-03-15T18:52:14.689" v="1400" actId="1036"/>
          <ac:spMkLst>
            <pc:docMk/>
            <pc:sldMk cId="922933440" sldId="259"/>
            <ac:spMk id="120" creationId="{CBC12B02-D8D6-764A-9ECE-DDD25A5B40DE}"/>
          </ac:spMkLst>
        </pc:spChg>
        <pc:picChg chg="del">
          <ac:chgData name="Zhu, Dihan" userId="5577ebe6-3386-48d4-b782-5fb52b4e7fc6" providerId="ADAL" clId="{4850DFDE-C21A-FB4E-8864-BACBDBBCA548}" dt="2021-03-15T15:22:39.790" v="0" actId="478"/>
          <ac:picMkLst>
            <pc:docMk/>
            <pc:sldMk cId="922933440" sldId="259"/>
            <ac:picMk id="3" creationId="{2E59EBBF-8F05-6B4A-9B0F-D3943516484F}"/>
          </ac:picMkLst>
        </pc:picChg>
        <pc:picChg chg="add mod modCrop">
          <ac:chgData name="Zhu, Dihan" userId="5577ebe6-3386-48d4-b782-5fb52b4e7fc6" providerId="ADAL" clId="{4850DFDE-C21A-FB4E-8864-BACBDBBCA548}" dt="2021-03-15T18:48:18.417" v="1267" actId="1076"/>
          <ac:picMkLst>
            <pc:docMk/>
            <pc:sldMk cId="922933440" sldId="259"/>
            <ac:picMk id="4" creationId="{4FBFF5D1-DA75-6445-9C17-DE9B4077D47E}"/>
          </ac:picMkLst>
        </pc:picChg>
        <pc:picChg chg="add mod modCrop">
          <ac:chgData name="Zhu, Dihan" userId="5577ebe6-3386-48d4-b782-5fb52b4e7fc6" providerId="ADAL" clId="{4850DFDE-C21A-FB4E-8864-BACBDBBCA548}" dt="2021-03-15T18:52:14.689" v="1400" actId="1036"/>
          <ac:picMkLst>
            <pc:docMk/>
            <pc:sldMk cId="922933440" sldId="259"/>
            <ac:picMk id="6" creationId="{E9428EF5-FA96-B749-8EE7-B6AE29229436}"/>
          </ac:picMkLst>
        </pc:picChg>
        <pc:picChg chg="del mod">
          <ac:chgData name="Zhu, Dihan" userId="5577ebe6-3386-48d4-b782-5fb52b4e7fc6" providerId="ADAL" clId="{4850DFDE-C21A-FB4E-8864-BACBDBBCA548}" dt="2021-03-15T15:22:51.716" v="4" actId="478"/>
          <ac:picMkLst>
            <pc:docMk/>
            <pc:sldMk cId="922933440" sldId="259"/>
            <ac:picMk id="7" creationId="{4C89200F-D580-BA48-BC45-DF0AF4C9DD3C}"/>
          </ac:picMkLst>
        </pc:picChg>
        <pc:picChg chg="del mod">
          <ac:chgData name="Zhu, Dihan" userId="5577ebe6-3386-48d4-b782-5fb52b4e7fc6" providerId="ADAL" clId="{4850DFDE-C21A-FB4E-8864-BACBDBBCA548}" dt="2021-03-15T15:26:45.128" v="114" actId="478"/>
          <ac:picMkLst>
            <pc:docMk/>
            <pc:sldMk cId="922933440" sldId="259"/>
            <ac:picMk id="9" creationId="{B4FE5F9C-2791-2747-A188-09951F172158}"/>
          </ac:picMkLst>
        </pc:picChg>
        <pc:picChg chg="add mod">
          <ac:chgData name="Zhu, Dihan" userId="5577ebe6-3386-48d4-b782-5fb52b4e7fc6" providerId="ADAL" clId="{4850DFDE-C21A-FB4E-8864-BACBDBBCA548}" dt="2021-03-15T18:52:14.689" v="1400" actId="1036"/>
          <ac:picMkLst>
            <pc:docMk/>
            <pc:sldMk cId="922933440" sldId="259"/>
            <ac:picMk id="10" creationId="{6116FA48-93B6-4344-9B34-F3CEB4189AB0}"/>
          </ac:picMkLst>
        </pc:picChg>
        <pc:picChg chg="del mod">
          <ac:chgData name="Zhu, Dihan" userId="5577ebe6-3386-48d4-b782-5fb52b4e7fc6" providerId="ADAL" clId="{4850DFDE-C21A-FB4E-8864-BACBDBBCA548}" dt="2021-03-15T15:26:43.020" v="113" actId="478"/>
          <ac:picMkLst>
            <pc:docMk/>
            <pc:sldMk cId="922933440" sldId="259"/>
            <ac:picMk id="11" creationId="{0B830DFD-68A4-014B-82AD-756E12CD58DC}"/>
          </ac:picMkLst>
        </pc:picChg>
        <pc:picChg chg="del mod">
          <ac:chgData name="Zhu, Dihan" userId="5577ebe6-3386-48d4-b782-5fb52b4e7fc6" providerId="ADAL" clId="{4850DFDE-C21A-FB4E-8864-BACBDBBCA548}" dt="2021-03-15T15:26:38.417" v="112" actId="478"/>
          <ac:picMkLst>
            <pc:docMk/>
            <pc:sldMk cId="922933440" sldId="259"/>
            <ac:picMk id="13" creationId="{B4DFADEB-38F8-304E-9E57-98CB19D9082F}"/>
          </ac:picMkLst>
        </pc:picChg>
        <pc:picChg chg="add del mod modCrop">
          <ac:chgData name="Zhu, Dihan" userId="5577ebe6-3386-48d4-b782-5fb52b4e7fc6" providerId="ADAL" clId="{4850DFDE-C21A-FB4E-8864-BACBDBBCA548}" dt="2021-03-15T15:48:17.333" v="596" actId="478"/>
          <ac:picMkLst>
            <pc:docMk/>
            <pc:sldMk cId="922933440" sldId="259"/>
            <ac:picMk id="14" creationId="{38BFF346-043E-B541-B172-3C270F17D8A4}"/>
          </ac:picMkLst>
        </pc:picChg>
        <pc:picChg chg="add del mod modCrop">
          <ac:chgData name="Zhu, Dihan" userId="5577ebe6-3386-48d4-b782-5fb52b4e7fc6" providerId="ADAL" clId="{4850DFDE-C21A-FB4E-8864-BACBDBBCA548}" dt="2021-03-15T18:48:56.629" v="1272" actId="21"/>
          <ac:picMkLst>
            <pc:docMk/>
            <pc:sldMk cId="922933440" sldId="259"/>
            <ac:picMk id="16" creationId="{F4CB201E-BDD1-8141-941E-A3A8546FC923}"/>
          </ac:picMkLst>
        </pc:picChg>
        <pc:picChg chg="add del mod">
          <ac:chgData name="Zhu, Dihan" userId="5577ebe6-3386-48d4-b782-5fb52b4e7fc6" providerId="ADAL" clId="{4850DFDE-C21A-FB4E-8864-BACBDBBCA548}" dt="2021-03-15T15:54:23.926" v="685" actId="478"/>
          <ac:picMkLst>
            <pc:docMk/>
            <pc:sldMk cId="922933440" sldId="259"/>
            <ac:picMk id="18" creationId="{5BE2CD8A-E1FE-1543-A6BC-483573DFDA9B}"/>
          </ac:picMkLst>
        </pc:picChg>
        <pc:picChg chg="add del mod modCrop">
          <ac:chgData name="Zhu, Dihan" userId="5577ebe6-3386-48d4-b782-5fb52b4e7fc6" providerId="ADAL" clId="{4850DFDE-C21A-FB4E-8864-BACBDBBCA548}" dt="2021-03-15T18:48:56.629" v="1272" actId="21"/>
          <ac:picMkLst>
            <pc:docMk/>
            <pc:sldMk cId="922933440" sldId="259"/>
            <ac:picMk id="20" creationId="{D3077005-47EA-4343-A53E-8FB8A409C269}"/>
          </ac:picMkLst>
        </pc:picChg>
        <pc:picChg chg="add del mod">
          <ac:chgData name="Zhu, Dihan" userId="5577ebe6-3386-48d4-b782-5fb52b4e7fc6" providerId="ADAL" clId="{4850DFDE-C21A-FB4E-8864-BACBDBBCA548}" dt="2021-03-15T15:33:16.587" v="260" actId="478"/>
          <ac:picMkLst>
            <pc:docMk/>
            <pc:sldMk cId="922933440" sldId="259"/>
            <ac:picMk id="22" creationId="{2B726F11-F5BE-C74D-AEFC-E1EE42A1485E}"/>
          </ac:picMkLst>
        </pc:picChg>
        <pc:picChg chg="add del mod">
          <ac:chgData name="Zhu, Dihan" userId="5577ebe6-3386-48d4-b782-5fb52b4e7fc6" providerId="ADAL" clId="{4850DFDE-C21A-FB4E-8864-BACBDBBCA548}" dt="2021-03-15T15:34:37.132" v="266" actId="478"/>
          <ac:picMkLst>
            <pc:docMk/>
            <pc:sldMk cId="922933440" sldId="259"/>
            <ac:picMk id="24" creationId="{9C5F12D0-397F-2E40-AB2E-9759611DD042}"/>
          </ac:picMkLst>
        </pc:picChg>
        <pc:picChg chg="add del mod modCrop">
          <ac:chgData name="Zhu, Dihan" userId="5577ebe6-3386-48d4-b782-5fb52b4e7fc6" providerId="ADAL" clId="{4850DFDE-C21A-FB4E-8864-BACBDBBCA548}" dt="2021-03-15T18:48:56.629" v="1272" actId="21"/>
          <ac:picMkLst>
            <pc:docMk/>
            <pc:sldMk cId="922933440" sldId="259"/>
            <ac:picMk id="26" creationId="{98AE6BE3-263E-C146-9D9F-156782665A84}"/>
          </ac:picMkLst>
        </pc:picChg>
        <pc:picChg chg="add del mod">
          <ac:chgData name="Zhu, Dihan" userId="5577ebe6-3386-48d4-b782-5fb52b4e7fc6" providerId="ADAL" clId="{4850DFDE-C21A-FB4E-8864-BACBDBBCA548}" dt="2021-03-15T15:44:31.028" v="564"/>
          <ac:picMkLst>
            <pc:docMk/>
            <pc:sldMk cId="922933440" sldId="259"/>
            <ac:picMk id="32" creationId="{E072954C-0088-2C49-8343-8605F72D307B}"/>
          </ac:picMkLst>
        </pc:picChg>
        <pc:picChg chg="add mod modCrop">
          <ac:chgData name="Zhu, Dihan" userId="5577ebe6-3386-48d4-b782-5fb52b4e7fc6" providerId="ADAL" clId="{4850DFDE-C21A-FB4E-8864-BACBDBBCA548}" dt="2021-03-15T18:52:14.689" v="1400" actId="1036"/>
          <ac:picMkLst>
            <pc:docMk/>
            <pc:sldMk cId="922933440" sldId="259"/>
            <ac:picMk id="36" creationId="{76379F2A-2D72-AC42-B32A-6B613CA0DC08}"/>
          </ac:picMkLst>
        </pc:picChg>
        <pc:picChg chg="add del mod">
          <ac:chgData name="Zhu, Dihan" userId="5577ebe6-3386-48d4-b782-5fb52b4e7fc6" providerId="ADAL" clId="{4850DFDE-C21A-FB4E-8864-BACBDBBCA548}" dt="2021-03-15T15:49:01.255" v="646" actId="478"/>
          <ac:picMkLst>
            <pc:docMk/>
            <pc:sldMk cId="922933440" sldId="259"/>
            <ac:picMk id="37" creationId="{251353CC-FF91-364C-81C9-C0A9C0945DA2}"/>
          </ac:picMkLst>
        </pc:picChg>
        <pc:picChg chg="add del mod modCrop">
          <ac:chgData name="Zhu, Dihan" userId="5577ebe6-3386-48d4-b782-5fb52b4e7fc6" providerId="ADAL" clId="{4850DFDE-C21A-FB4E-8864-BACBDBBCA548}" dt="2021-03-15T18:48:56.629" v="1272" actId="21"/>
          <ac:picMkLst>
            <pc:docMk/>
            <pc:sldMk cId="922933440" sldId="259"/>
            <ac:picMk id="40" creationId="{6885BAD1-B939-3C47-BDAB-A30B3AF98181}"/>
          </ac:picMkLst>
        </pc:picChg>
        <pc:picChg chg="add del mod">
          <ac:chgData name="Zhu, Dihan" userId="5577ebe6-3386-48d4-b782-5fb52b4e7fc6" providerId="ADAL" clId="{4850DFDE-C21A-FB4E-8864-BACBDBBCA548}" dt="2021-03-15T18:48:56.629" v="1272" actId="21"/>
          <ac:picMkLst>
            <pc:docMk/>
            <pc:sldMk cId="922933440" sldId="259"/>
            <ac:picMk id="68" creationId="{B39E6B1E-E332-CB43-B9D9-203343926CC0}"/>
          </ac:picMkLst>
        </pc:picChg>
        <pc:picChg chg="add del mod">
          <ac:chgData name="Zhu, Dihan" userId="5577ebe6-3386-48d4-b782-5fb52b4e7fc6" providerId="ADAL" clId="{4850DFDE-C21A-FB4E-8864-BACBDBBCA548}" dt="2021-03-15T18:42:57.926" v="1173" actId="478"/>
          <ac:picMkLst>
            <pc:docMk/>
            <pc:sldMk cId="922933440" sldId="259"/>
            <ac:picMk id="110" creationId="{722F60E0-4DDB-2F4E-8143-93E108A854FC}"/>
          </ac:picMkLst>
        </pc:picChg>
        <pc:cxnChg chg="add del mod">
          <ac:chgData name="Zhu, Dihan" userId="5577ebe6-3386-48d4-b782-5fb52b4e7fc6" providerId="ADAL" clId="{4850DFDE-C21A-FB4E-8864-BACBDBBCA548}" dt="2021-03-15T18:48:56.629" v="1272" actId="21"/>
          <ac:cxnSpMkLst>
            <pc:docMk/>
            <pc:sldMk cId="922933440" sldId="259"/>
            <ac:cxnSpMk id="78" creationId="{AC1053CB-4860-CC45-9FFE-7C32F9A1CED5}"/>
          </ac:cxnSpMkLst>
        </pc:cxnChg>
      </pc:sldChg>
      <pc:sldChg chg="addSp modSp new mod">
        <pc:chgData name="Zhu, Dihan" userId="5577ebe6-3386-48d4-b782-5fb52b4e7fc6" providerId="ADAL" clId="{4850DFDE-C21A-FB4E-8864-BACBDBBCA548}" dt="2021-03-15T18:51:12.448" v="1371" actId="1076"/>
        <pc:sldMkLst>
          <pc:docMk/>
          <pc:sldMk cId="80484632" sldId="260"/>
        </pc:sldMkLst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" creationId="{63403E06-24B9-D345-B824-94D196FB008F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7" creationId="{338BE40C-088B-6A41-A9C9-10343D17DD54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8" creationId="{E10274AA-F6C7-7C47-843E-3F210E040DBA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9" creationId="{2D5B6529-888B-BB4C-961E-19F0255AEC28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10" creationId="{082D9295-1B50-FE4F-9E45-7F6B5E2A2323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11" creationId="{A954DB55-C613-0745-BF1F-A9775DDDC774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12" creationId="{4ACD79C7-0532-194A-8770-2C97901755C0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13" creationId="{BE040896-A5E4-5A40-A051-10AAD8DB8E7C}"/>
          </ac:spMkLst>
        </pc:spChg>
        <pc:spChg chg="add mod">
          <ac:chgData name="Zhu, Dihan" userId="5577ebe6-3386-48d4-b782-5fb52b4e7fc6" providerId="ADAL" clId="{4850DFDE-C21A-FB4E-8864-BACBDBBCA548}" dt="2021-03-15T18:50:13.608" v="1327" actId="1035"/>
          <ac:spMkLst>
            <pc:docMk/>
            <pc:sldMk cId="80484632" sldId="260"/>
            <ac:spMk id="14" creationId="{17AC9168-72AC-8946-8981-73FFD6244FE2}"/>
          </ac:spMkLst>
        </pc:spChg>
        <pc:spChg chg="add mod">
          <ac:chgData name="Zhu, Dihan" userId="5577ebe6-3386-48d4-b782-5fb52b4e7fc6" providerId="ADAL" clId="{4850DFDE-C21A-FB4E-8864-BACBDBBCA548}" dt="2021-03-15T18:50:36.087" v="1366" actId="1035"/>
          <ac:spMkLst>
            <pc:docMk/>
            <pc:sldMk cId="80484632" sldId="260"/>
            <ac:spMk id="15" creationId="{EAEE1B1D-7567-C848-8111-4B5B14430DBA}"/>
          </ac:spMkLst>
        </pc:spChg>
        <pc:spChg chg="add mod">
          <ac:chgData name="Zhu, Dihan" userId="5577ebe6-3386-48d4-b782-5fb52b4e7fc6" providerId="ADAL" clId="{4850DFDE-C21A-FB4E-8864-BACBDBBCA548}" dt="2021-03-15T18:49:11.841" v="1275" actId="1076"/>
          <ac:spMkLst>
            <pc:docMk/>
            <pc:sldMk cId="80484632" sldId="260"/>
            <ac:spMk id="16" creationId="{5F587C79-26F0-D24B-96A0-2299DD0F3CC2}"/>
          </ac:spMkLst>
        </pc:spChg>
        <pc:spChg chg="add mod">
          <ac:chgData name="Zhu, Dihan" userId="5577ebe6-3386-48d4-b782-5fb52b4e7fc6" providerId="ADAL" clId="{4850DFDE-C21A-FB4E-8864-BACBDBBCA548}" dt="2021-03-15T18:49:46.743" v="1290" actId="1035"/>
          <ac:spMkLst>
            <pc:docMk/>
            <pc:sldMk cId="80484632" sldId="260"/>
            <ac:spMk id="17" creationId="{FDBF04CE-3726-A84B-AEE0-54245F2296B4}"/>
          </ac:spMkLst>
        </pc:spChg>
        <pc:spChg chg="add mod">
          <ac:chgData name="Zhu, Dihan" userId="5577ebe6-3386-48d4-b782-5fb52b4e7fc6" providerId="ADAL" clId="{4850DFDE-C21A-FB4E-8864-BACBDBBCA548}" dt="2021-03-15T18:50:36.087" v="1366" actId="1035"/>
          <ac:spMkLst>
            <pc:docMk/>
            <pc:sldMk cId="80484632" sldId="260"/>
            <ac:spMk id="18" creationId="{01CADFE5-0517-E245-9C78-45EFB998438D}"/>
          </ac:spMkLst>
        </pc:spChg>
        <pc:spChg chg="add mod">
          <ac:chgData name="Zhu, Dihan" userId="5577ebe6-3386-48d4-b782-5fb52b4e7fc6" providerId="ADAL" clId="{4850DFDE-C21A-FB4E-8864-BACBDBBCA548}" dt="2021-03-15T18:50:13.608" v="1327" actId="1035"/>
          <ac:spMkLst>
            <pc:docMk/>
            <pc:sldMk cId="80484632" sldId="260"/>
            <ac:spMk id="19" creationId="{3601368C-70D1-7541-97B0-FBA052C39E89}"/>
          </ac:spMkLst>
        </pc:spChg>
        <pc:spChg chg="add mod">
          <ac:chgData name="Zhu, Dihan" userId="5577ebe6-3386-48d4-b782-5fb52b4e7fc6" providerId="ADAL" clId="{4850DFDE-C21A-FB4E-8864-BACBDBBCA548}" dt="2021-03-15T18:49:11.841" v="1275" actId="1076"/>
          <ac:spMkLst>
            <pc:docMk/>
            <pc:sldMk cId="80484632" sldId="260"/>
            <ac:spMk id="20" creationId="{51E27330-A106-9248-A4AE-B43FA331D7DF}"/>
          </ac:spMkLst>
        </pc:spChg>
        <pc:spChg chg="add mod">
          <ac:chgData name="Zhu, Dihan" userId="5577ebe6-3386-48d4-b782-5fb52b4e7fc6" providerId="ADAL" clId="{4850DFDE-C21A-FB4E-8864-BACBDBBCA548}" dt="2021-03-15T18:49:46.743" v="1290" actId="1035"/>
          <ac:spMkLst>
            <pc:docMk/>
            <pc:sldMk cId="80484632" sldId="260"/>
            <ac:spMk id="21" creationId="{BF1AE4D4-4DB6-E148-939D-4BA20A0221C8}"/>
          </ac:spMkLst>
        </pc:spChg>
        <pc:spChg chg="add mod">
          <ac:chgData name="Zhu, Dihan" userId="5577ebe6-3386-48d4-b782-5fb52b4e7fc6" providerId="ADAL" clId="{4850DFDE-C21A-FB4E-8864-BACBDBBCA548}" dt="2021-03-15T18:49:11.841" v="1275" actId="1076"/>
          <ac:spMkLst>
            <pc:docMk/>
            <pc:sldMk cId="80484632" sldId="260"/>
            <ac:spMk id="22" creationId="{B13E1C08-B7A0-9541-B503-C05ACB722D8C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24" creationId="{22AFB5E0-74F5-944D-A680-5923924ECF59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25" creationId="{78DEAE9D-992D-9C4D-BCA9-7F5BB8BCD5E2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26" creationId="{23F9F725-4574-DC40-8BBD-0B1DD49126FB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27" creationId="{AB23B35C-65EF-2B44-BE36-7851A85B6160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28" creationId="{3FC49924-63DF-C647-9003-7A96D2AA97B2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29" creationId="{51C4576A-EF70-6740-B74C-900C46E91AAF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30" creationId="{3BF89F49-DBB6-1546-95F9-9164FDCBBEE9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31" creationId="{B6F0D4ED-A76A-114F-8BE5-F95C850F4ABC}"/>
          </ac:spMkLst>
        </pc:spChg>
        <pc:spChg chg="add mod">
          <ac:chgData name="Zhu, Dihan" userId="5577ebe6-3386-48d4-b782-5fb52b4e7fc6" providerId="ADAL" clId="{4850DFDE-C21A-FB4E-8864-BACBDBBCA548}" dt="2021-03-15T18:51:12.448" v="1371" actId="1076"/>
          <ac:spMkLst>
            <pc:docMk/>
            <pc:sldMk cId="80484632" sldId="260"/>
            <ac:spMk id="32" creationId="{7E633361-CDEC-E846-AA96-198A3A250C1B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34" creationId="{A6737289-6883-7644-AD1E-8A42E685D1AC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35" creationId="{B9CC7818-5F77-D343-AF72-AD5A4EA65B55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36" creationId="{31ACCD24-00E1-6E4D-84AF-890B8DB54108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37" creationId="{63E02BC3-CB36-474B-8209-E2A3CC7BBE96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38" creationId="{BD44EC56-2CA4-F848-99FB-CC3EE50BD7C2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39" creationId="{6CF0308D-F17D-0447-BB70-7C96EEF2611C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0" creationId="{6CEB1826-6EF1-0641-9B09-538E41E7779C}"/>
          </ac:spMkLst>
        </pc:spChg>
        <pc:spChg chg="add mod">
          <ac:chgData name="Zhu, Dihan" userId="5577ebe6-3386-48d4-b782-5fb52b4e7fc6" providerId="ADAL" clId="{4850DFDE-C21A-FB4E-8864-BACBDBBCA548}" dt="2021-03-15T18:50:51.124" v="1368" actId="403"/>
          <ac:spMkLst>
            <pc:docMk/>
            <pc:sldMk cId="80484632" sldId="260"/>
            <ac:spMk id="41" creationId="{F4B33D96-48DB-A64B-99A6-8F767CBC6445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2" creationId="{98DD9E23-724A-CD40-B8B7-2108B60F3ABE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3" creationId="{E9E552B2-A749-D94C-A7B0-FD724836D5DC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4" creationId="{D9BE3183-C33F-4B45-A68B-56691FE074AA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5" creationId="{D4658DF3-C739-EC47-922B-F981DAA44368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6" creationId="{CB1E4AD7-6573-6546-8A1D-47AF3AF3C8B8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7" creationId="{121C7D24-C1AE-1E4A-BEEA-23C411C7CCA0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48" creationId="{071B9904-B5FF-FD45-85B6-57E5C529DBAC}"/>
          </ac:spMkLst>
        </pc:spChg>
        <pc:spChg chg="add mod">
          <ac:chgData name="Zhu, Dihan" userId="5577ebe6-3386-48d4-b782-5fb52b4e7fc6" providerId="ADAL" clId="{4850DFDE-C21A-FB4E-8864-BACBDBBCA548}" dt="2021-03-15T18:49:46.743" v="1290" actId="1035"/>
          <ac:spMkLst>
            <pc:docMk/>
            <pc:sldMk cId="80484632" sldId="260"/>
            <ac:spMk id="49" creationId="{35F454AE-DA89-FD49-9864-ABB417F6808B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0" creationId="{FC0E83F9-6925-F24E-9B20-6806CE7035AF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1" creationId="{EC443606-933D-2E4D-B04E-AE2298915D05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2" creationId="{E2C4EEE3-9354-CE42-9940-2558F0CA93AC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3" creationId="{C2A7076C-9DBD-5D4D-A97E-71F79100BED4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4" creationId="{BB8DDF86-B6E4-9241-884C-3FC55FCC9F6E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5" creationId="{6F6CA058-278B-4F4C-B4F2-6575A95BF894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6" creationId="{24903076-5B99-1A49-9A09-1B0D4CCF0E46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7" creationId="{89956269-28F0-8348-87F0-0E76536D628C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8" creationId="{979513E3-7F1E-5B4C-A96F-0C04B4597142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59" creationId="{E879431B-1521-1240-87D7-1DD4F73D27BD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0" creationId="{AA5CF6EC-9043-9B47-AD51-AE0B38237872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1" creationId="{417CC09A-6B8A-BF4C-BA8F-C1D834E7D40C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2" creationId="{BF619412-4148-EF4B-AB0D-0B0C0CB26A8B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3" creationId="{8CFA1953-8B83-DF46-BFE2-E04CE6C55AA1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4" creationId="{2D950016-DE24-2642-BEA8-D739725FDD3E}"/>
          </ac:spMkLst>
        </pc:spChg>
        <pc:spChg chg="add mod">
          <ac:chgData name="Zhu, Dihan" userId="5577ebe6-3386-48d4-b782-5fb52b4e7fc6" providerId="ADAL" clId="{4850DFDE-C21A-FB4E-8864-BACBDBBCA548}" dt="2021-03-15T18:50:45.462" v="1367" actId="255"/>
          <ac:spMkLst>
            <pc:docMk/>
            <pc:sldMk cId="80484632" sldId="260"/>
            <ac:spMk id="65" creationId="{F728D89E-56AB-1245-93B2-EB2A7D369023}"/>
          </ac:spMkLst>
        </pc:spChg>
        <pc:picChg chg="add mod">
          <ac:chgData name="Zhu, Dihan" userId="5577ebe6-3386-48d4-b782-5fb52b4e7fc6" providerId="ADAL" clId="{4850DFDE-C21A-FB4E-8864-BACBDBBCA548}" dt="2021-03-15T18:49:11.841" v="1275" actId="1076"/>
          <ac:picMkLst>
            <pc:docMk/>
            <pc:sldMk cId="80484632" sldId="260"/>
            <ac:picMk id="2" creationId="{87DD172D-A228-ED48-A37F-393F2D56BC4E}"/>
          </ac:picMkLst>
        </pc:picChg>
        <pc:picChg chg="add mod">
          <ac:chgData name="Zhu, Dihan" userId="5577ebe6-3386-48d4-b782-5fb52b4e7fc6" providerId="ADAL" clId="{4850DFDE-C21A-FB4E-8864-BACBDBBCA548}" dt="2021-03-15T18:50:13.608" v="1327" actId="1035"/>
          <ac:picMkLst>
            <pc:docMk/>
            <pc:sldMk cId="80484632" sldId="260"/>
            <ac:picMk id="3" creationId="{F0B05961-9BA3-7E4E-8448-87246559095E}"/>
          </ac:picMkLst>
        </pc:picChg>
        <pc:picChg chg="add mod">
          <ac:chgData name="Zhu, Dihan" userId="5577ebe6-3386-48d4-b782-5fb52b4e7fc6" providerId="ADAL" clId="{4850DFDE-C21A-FB4E-8864-BACBDBBCA548}" dt="2021-03-15T18:49:46.743" v="1290" actId="1035"/>
          <ac:picMkLst>
            <pc:docMk/>
            <pc:sldMk cId="80484632" sldId="260"/>
            <ac:picMk id="4" creationId="{2F925056-6CEF-2A4E-8A43-CFE93A07E8BE}"/>
          </ac:picMkLst>
        </pc:picChg>
        <pc:picChg chg="add mod">
          <ac:chgData name="Zhu, Dihan" userId="5577ebe6-3386-48d4-b782-5fb52b4e7fc6" providerId="ADAL" clId="{4850DFDE-C21A-FB4E-8864-BACBDBBCA548}" dt="2021-03-15T18:50:36.087" v="1366" actId="1035"/>
          <ac:picMkLst>
            <pc:docMk/>
            <pc:sldMk cId="80484632" sldId="260"/>
            <ac:picMk id="5" creationId="{5ACA8A28-A3DF-A84B-9AD7-AD1E5FF06246}"/>
          </ac:picMkLst>
        </pc:picChg>
        <pc:picChg chg="add mod">
          <ac:chgData name="Zhu, Dihan" userId="5577ebe6-3386-48d4-b782-5fb52b4e7fc6" providerId="ADAL" clId="{4850DFDE-C21A-FB4E-8864-BACBDBBCA548}" dt="2021-03-15T18:51:12.448" v="1371" actId="1076"/>
          <ac:picMkLst>
            <pc:docMk/>
            <pc:sldMk cId="80484632" sldId="260"/>
            <ac:picMk id="23" creationId="{E7ED869E-02D5-2E45-B107-DE078D720562}"/>
          </ac:picMkLst>
        </pc:picChg>
        <pc:cxnChg chg="add mod">
          <ac:chgData name="Zhu, Dihan" userId="5577ebe6-3386-48d4-b782-5fb52b4e7fc6" providerId="ADAL" clId="{4850DFDE-C21A-FB4E-8864-BACBDBBCA548}" dt="2021-03-15T18:51:12.448" v="1371" actId="1076"/>
          <ac:cxnSpMkLst>
            <pc:docMk/>
            <pc:sldMk cId="80484632" sldId="260"/>
            <ac:cxnSpMk id="33" creationId="{E5372BD8-069D-7C4D-A680-7641335C17F8}"/>
          </ac:cxnSpMkLst>
        </pc:cxnChg>
      </pc:sldChg>
    </pc:docChg>
  </pc:docChgLst>
  <pc:docChgLst>
    <pc:chgData name="Zhu, Dihan" userId="5577ebe6-3386-48d4-b782-5fb52b4e7fc6" providerId="ADAL" clId="{098703EE-11E6-6C4C-9F18-D6A7F677B704}"/>
    <pc:docChg chg="custSel modSld">
      <pc:chgData name="Zhu, Dihan" userId="5577ebe6-3386-48d4-b782-5fb52b4e7fc6" providerId="ADAL" clId="{098703EE-11E6-6C4C-9F18-D6A7F677B704}" dt="2021-05-09T16:19:19.679" v="209" actId="20577"/>
      <pc:docMkLst>
        <pc:docMk/>
      </pc:docMkLst>
      <pc:sldChg chg="addSp delSp modSp mod">
        <pc:chgData name="Zhu, Dihan" userId="5577ebe6-3386-48d4-b782-5fb52b4e7fc6" providerId="ADAL" clId="{098703EE-11E6-6C4C-9F18-D6A7F677B704}" dt="2021-05-09T16:19:19.679" v="209" actId="20577"/>
        <pc:sldMkLst>
          <pc:docMk/>
          <pc:sldMk cId="702057605" sldId="257"/>
        </pc:sldMkLst>
        <pc:spChg chg="mod">
          <ac:chgData name="Zhu, Dihan" userId="5577ebe6-3386-48d4-b782-5fb52b4e7fc6" providerId="ADAL" clId="{098703EE-11E6-6C4C-9F18-D6A7F677B704}" dt="2021-05-09T16:11:12.109" v="108" actId="1037"/>
          <ac:spMkLst>
            <pc:docMk/>
            <pc:sldMk cId="702057605" sldId="257"/>
            <ac:spMk id="5" creationId="{FBEB69D9-8ED5-48D5-950C-E34E4AB0B81F}"/>
          </ac:spMkLst>
        </pc:spChg>
        <pc:spChg chg="mod">
          <ac:chgData name="Zhu, Dihan" userId="5577ebe6-3386-48d4-b782-5fb52b4e7fc6" providerId="ADAL" clId="{098703EE-11E6-6C4C-9F18-D6A7F677B704}" dt="2021-05-09T16:17:46.932" v="166" actId="1036"/>
          <ac:spMkLst>
            <pc:docMk/>
            <pc:sldMk cId="702057605" sldId="257"/>
            <ac:spMk id="9" creationId="{84D4A846-852D-40C7-8AE4-8CA7182D4545}"/>
          </ac:spMkLst>
        </pc:spChg>
        <pc:spChg chg="mod">
          <ac:chgData name="Zhu, Dihan" userId="5577ebe6-3386-48d4-b782-5fb52b4e7fc6" providerId="ADAL" clId="{098703EE-11E6-6C4C-9F18-D6A7F677B704}" dt="2021-05-09T16:19:19.679" v="209" actId="20577"/>
          <ac:spMkLst>
            <pc:docMk/>
            <pc:sldMk cId="702057605" sldId="257"/>
            <ac:spMk id="29" creationId="{CCEBF5CF-DC9B-465F-A833-35F17C25DC8B}"/>
          </ac:spMkLst>
        </pc:spChg>
        <pc:graphicFrameChg chg="del">
          <ac:chgData name="Zhu, Dihan" userId="5577ebe6-3386-48d4-b782-5fb52b4e7fc6" providerId="ADAL" clId="{098703EE-11E6-6C4C-9F18-D6A7F677B704}" dt="2021-05-09T16:09:59.637" v="40" actId="478"/>
          <ac:graphicFrameMkLst>
            <pc:docMk/>
            <pc:sldMk cId="702057605" sldId="257"/>
            <ac:graphicFrameMk id="2" creationId="{22E31561-3957-473E-A657-4CED68735DBF}"/>
          </ac:graphicFrameMkLst>
        </pc:graphicFrameChg>
        <pc:graphicFrameChg chg="mod">
          <ac:chgData name="Zhu, Dihan" userId="5577ebe6-3386-48d4-b782-5fb52b4e7fc6" providerId="ADAL" clId="{098703EE-11E6-6C4C-9F18-D6A7F677B704}" dt="2021-05-09T16:18:36.125" v="179"/>
          <ac:graphicFrameMkLst>
            <pc:docMk/>
            <pc:sldMk cId="702057605" sldId="257"/>
            <ac:graphicFrameMk id="3" creationId="{207339A8-1295-4576-8AFF-B090DCDD2D96}"/>
          </ac:graphicFrameMkLst>
        </pc:graphicFrameChg>
        <pc:graphicFrameChg chg="mod">
          <ac:chgData name="Zhu, Dihan" userId="5577ebe6-3386-48d4-b782-5fb52b4e7fc6" providerId="ADAL" clId="{098703EE-11E6-6C4C-9F18-D6A7F677B704}" dt="2021-05-09T16:11:01.518" v="100" actId="167"/>
          <ac:graphicFrameMkLst>
            <pc:docMk/>
            <pc:sldMk cId="702057605" sldId="257"/>
            <ac:graphicFrameMk id="22" creationId="{A2EA0E59-0209-4BCC-BF5B-1867FD4D90A3}"/>
          </ac:graphicFrameMkLst>
        </pc:graphicFrameChg>
        <pc:graphicFrameChg chg="add mod">
          <ac:chgData name="Zhu, Dihan" userId="5577ebe6-3386-48d4-b782-5fb52b4e7fc6" providerId="ADAL" clId="{098703EE-11E6-6C4C-9F18-D6A7F677B704}" dt="2021-05-09T16:10:57.339" v="99" actId="167"/>
          <ac:graphicFrameMkLst>
            <pc:docMk/>
            <pc:sldMk cId="702057605" sldId="257"/>
            <ac:graphicFrameMk id="28" creationId="{43A7D139-A6F1-F949-9AC9-FEE29AB1041E}"/>
          </ac:graphicFrameMkLst>
        </pc:graphicFrameChg>
        <pc:cxnChg chg="mod">
          <ac:chgData name="Zhu, Dihan" userId="5577ebe6-3386-48d4-b782-5fb52b4e7fc6" providerId="ADAL" clId="{098703EE-11E6-6C4C-9F18-D6A7F677B704}" dt="2021-05-09T16:10:39.037" v="84" actId="1036"/>
          <ac:cxnSpMkLst>
            <pc:docMk/>
            <pc:sldMk cId="702057605" sldId="257"/>
            <ac:cxnSpMk id="7" creationId="{657752D8-C80E-4107-8E9A-643C3314AA21}"/>
          </ac:cxnSpMkLst>
        </pc:cxnChg>
        <pc:cxnChg chg="mod">
          <ac:chgData name="Zhu, Dihan" userId="5577ebe6-3386-48d4-b782-5fb52b4e7fc6" providerId="ADAL" clId="{098703EE-11E6-6C4C-9F18-D6A7F677B704}" dt="2021-05-09T16:17:46.932" v="166" actId="1036"/>
          <ac:cxnSpMkLst>
            <pc:docMk/>
            <pc:sldMk cId="702057605" sldId="257"/>
            <ac:cxnSpMk id="8" creationId="{BAF85874-CA9F-4E64-9B99-6B4328A90BCA}"/>
          </ac:cxnSpMkLst>
        </pc:cxnChg>
      </pc:sldChg>
    </pc:docChg>
  </pc:docChgLst>
  <pc:docChgLst>
    <pc:chgData name="Zhu, Dihan" userId="5577ebe6-3386-48d4-b782-5fb52b4e7fc6" providerId="ADAL" clId="{DB3ED4E5-1DFD-3C43-AB5C-DDC59D2259E6}"/>
    <pc:docChg chg="custSel addSld modSld">
      <pc:chgData name="Zhu, Dihan" userId="5577ebe6-3386-48d4-b782-5fb52b4e7fc6" providerId="ADAL" clId="{DB3ED4E5-1DFD-3C43-AB5C-DDC59D2259E6}" dt="2021-03-14T16:56:33.271" v="59" actId="1076"/>
      <pc:docMkLst>
        <pc:docMk/>
      </pc:docMkLst>
      <pc:sldChg chg="addSp delSp modSp new mod">
        <pc:chgData name="Zhu, Dihan" userId="5577ebe6-3386-48d4-b782-5fb52b4e7fc6" providerId="ADAL" clId="{DB3ED4E5-1DFD-3C43-AB5C-DDC59D2259E6}" dt="2021-03-14T16:56:33.271" v="59" actId="1076"/>
        <pc:sldMkLst>
          <pc:docMk/>
          <pc:sldMk cId="922933440" sldId="259"/>
        </pc:sldMkLst>
        <pc:picChg chg="add mod">
          <ac:chgData name="Zhu, Dihan" userId="5577ebe6-3386-48d4-b782-5fb52b4e7fc6" providerId="ADAL" clId="{DB3ED4E5-1DFD-3C43-AB5C-DDC59D2259E6}" dt="2021-03-13T22:51:56.513" v="53" actId="1076"/>
          <ac:picMkLst>
            <pc:docMk/>
            <pc:sldMk cId="922933440" sldId="259"/>
            <ac:picMk id="3" creationId="{2E59EBBF-8F05-6B4A-9B0F-D3943516484F}"/>
          </ac:picMkLst>
        </pc:picChg>
        <pc:picChg chg="add del mod">
          <ac:chgData name="Zhu, Dihan" userId="5577ebe6-3386-48d4-b782-5fb52b4e7fc6" providerId="ADAL" clId="{DB3ED4E5-1DFD-3C43-AB5C-DDC59D2259E6}" dt="2021-03-13T22:37:55.675" v="13" actId="478"/>
          <ac:picMkLst>
            <pc:docMk/>
            <pc:sldMk cId="922933440" sldId="259"/>
            <ac:picMk id="5" creationId="{350DFF6D-F501-424E-AE5A-CC01EC2557CE}"/>
          </ac:picMkLst>
        </pc:picChg>
        <pc:picChg chg="add mod">
          <ac:chgData name="Zhu, Dihan" userId="5577ebe6-3386-48d4-b782-5fb52b4e7fc6" providerId="ADAL" clId="{DB3ED4E5-1DFD-3C43-AB5C-DDC59D2259E6}" dt="2021-03-13T22:51:27.387" v="46" actId="1076"/>
          <ac:picMkLst>
            <pc:docMk/>
            <pc:sldMk cId="922933440" sldId="259"/>
            <ac:picMk id="7" creationId="{4C89200F-D580-BA48-BC45-DF0AF4C9DD3C}"/>
          </ac:picMkLst>
        </pc:picChg>
        <pc:picChg chg="add mod">
          <ac:chgData name="Zhu, Dihan" userId="5577ebe6-3386-48d4-b782-5fb52b4e7fc6" providerId="ADAL" clId="{DB3ED4E5-1DFD-3C43-AB5C-DDC59D2259E6}" dt="2021-03-14T16:56:33.271" v="59" actId="1076"/>
          <ac:picMkLst>
            <pc:docMk/>
            <pc:sldMk cId="922933440" sldId="259"/>
            <ac:picMk id="9" creationId="{B4FE5F9C-2791-2747-A188-09951F172158}"/>
          </ac:picMkLst>
        </pc:picChg>
        <pc:picChg chg="add mod">
          <ac:chgData name="Zhu, Dihan" userId="5577ebe6-3386-48d4-b782-5fb52b4e7fc6" providerId="ADAL" clId="{DB3ED4E5-1DFD-3C43-AB5C-DDC59D2259E6}" dt="2021-03-13T22:49:53.045" v="33" actId="14100"/>
          <ac:picMkLst>
            <pc:docMk/>
            <pc:sldMk cId="922933440" sldId="259"/>
            <ac:picMk id="11" creationId="{0B830DFD-68A4-014B-82AD-756E12CD58DC}"/>
          </ac:picMkLst>
        </pc:picChg>
        <pc:picChg chg="add mod">
          <ac:chgData name="Zhu, Dihan" userId="5577ebe6-3386-48d4-b782-5fb52b4e7fc6" providerId="ADAL" clId="{DB3ED4E5-1DFD-3C43-AB5C-DDC59D2259E6}" dt="2021-03-13T22:52:23.941" v="58" actId="14100"/>
          <ac:picMkLst>
            <pc:docMk/>
            <pc:sldMk cId="922933440" sldId="259"/>
            <ac:picMk id="13" creationId="{B4DFADEB-38F8-304E-9E57-98CB19D9082F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msmo365-my.sharepoint.com/personal/dzhu_msm_edu/Documents/SC1/Fig%205B%20Tube%20formation/2019-10-18/statistic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msmo365-my.sharepoint.com/personal/dzhu_msm_edu/Documents/SC1/Fig%205/Fig%205B%20Tube%20formation/statistic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msmo365-my.sharepoint.com/personal/dzhu_msm_edu/Documents/SC1/Fig%205B%20Tube%20formation/2019-10-18/statistic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C$8,Sheet1!$E$8:$I$8)</c:f>
                <c:numCache>
                  <c:formatCode>General</c:formatCode>
                  <c:ptCount val="6"/>
                  <c:pt idx="0">
                    <c:v>7.7190241179396075</c:v>
                  </c:pt>
                  <c:pt idx="1">
                    <c:v>32.745228660065884</c:v>
                  </c:pt>
                  <c:pt idx="2">
                    <c:v>21.322914122292634</c:v>
                  </c:pt>
                  <c:pt idx="3">
                    <c:v>23.530122538284125</c:v>
                  </c:pt>
                  <c:pt idx="4">
                    <c:v>24.576411454889016</c:v>
                  </c:pt>
                  <c:pt idx="5">
                    <c:v>17.540429489230494</c:v>
                  </c:pt>
                </c:numCache>
              </c:numRef>
            </c:plus>
            <c:minus>
              <c:numRef>
                <c:f>(Sheet1!$C$8,Sheet1!$E$8:$I$8)</c:f>
                <c:numCache>
                  <c:formatCode>General</c:formatCode>
                  <c:ptCount val="6"/>
                  <c:pt idx="0">
                    <c:v>7.7190241179396075</c:v>
                  </c:pt>
                  <c:pt idx="1">
                    <c:v>32.745228660065884</c:v>
                  </c:pt>
                  <c:pt idx="2">
                    <c:v>21.322914122292634</c:v>
                  </c:pt>
                  <c:pt idx="3">
                    <c:v>23.530122538284125</c:v>
                  </c:pt>
                  <c:pt idx="4">
                    <c:v>24.576411454889016</c:v>
                  </c:pt>
                  <c:pt idx="5">
                    <c:v>17.54042948923049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C$2,Sheet1!$E$2:$I$2)</c:f>
              <c:strCache>
                <c:ptCount val="6"/>
                <c:pt idx="0">
                  <c:v>PBS</c:v>
                </c:pt>
                <c:pt idx="1">
                  <c:v>P-MV</c:v>
                </c:pt>
                <c:pt idx="2">
                  <c:v>ZipmiR-Cont</c:v>
                </c:pt>
                <c:pt idx="3">
                  <c:v>ZipmiR-31</c:v>
                </c:pt>
                <c:pt idx="4">
                  <c:v>Lenti-CTL</c:v>
                </c:pt>
                <c:pt idx="5">
                  <c:v>Lenti-FIH</c:v>
                </c:pt>
              </c:strCache>
            </c:strRef>
          </c:cat>
          <c:val>
            <c:numRef>
              <c:f>(Sheet1!$C$7,Sheet1!$E$7:$I$7)</c:f>
              <c:numCache>
                <c:formatCode>General</c:formatCode>
                <c:ptCount val="6"/>
                <c:pt idx="0">
                  <c:v>63.75</c:v>
                </c:pt>
                <c:pt idx="1">
                  <c:v>255.75</c:v>
                </c:pt>
                <c:pt idx="2">
                  <c:v>276</c:v>
                </c:pt>
                <c:pt idx="3">
                  <c:v>153.5</c:v>
                </c:pt>
                <c:pt idx="4">
                  <c:v>228</c:v>
                </c:pt>
                <c:pt idx="5">
                  <c:v>14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2CF-4676-B3BF-67A52ED46AA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273792"/>
        <c:axId val="1127083808"/>
      </c:barChart>
      <c:catAx>
        <c:axId val="1074273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27083808"/>
        <c:crosses val="autoZero"/>
        <c:auto val="1"/>
        <c:lblAlgn val="ctr"/>
        <c:lblOffset val="100"/>
        <c:noMultiLvlLbl val="0"/>
      </c:catAx>
      <c:valAx>
        <c:axId val="1127083808"/>
        <c:scaling>
          <c:orientation val="minMax"/>
          <c:max val="3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Total junctions</a:t>
                </a:r>
              </a:p>
            </c:rich>
          </c:tx>
          <c:layout>
            <c:manualLayout>
              <c:xMode val="edge"/>
              <c:yMode val="edge"/>
              <c:x val="5.4220337167439542E-2"/>
              <c:y val="4.032203480030153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74273792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975554132755167"/>
          <c:y val="7.49224790198426E-2"/>
          <c:w val="0.67507368120408362"/>
          <c:h val="0.5168809940471086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Meshes!$C$9,Meshes!$E$9:$I$9)</c:f>
                <c:numCache>
                  <c:formatCode>General</c:formatCode>
                  <c:ptCount val="6"/>
                  <c:pt idx="0">
                    <c:v>3.1091263510296048</c:v>
                  </c:pt>
                  <c:pt idx="1">
                    <c:v>6.6520673478250352</c:v>
                  </c:pt>
                  <c:pt idx="2">
                    <c:v>5.4772255750516612</c:v>
                  </c:pt>
                  <c:pt idx="3">
                    <c:v>3.5</c:v>
                  </c:pt>
                  <c:pt idx="4">
                    <c:v>4.6904157598234297</c:v>
                  </c:pt>
                  <c:pt idx="5">
                    <c:v>2.753785273643051</c:v>
                  </c:pt>
                </c:numCache>
              </c:numRef>
            </c:plus>
            <c:minus>
              <c:numRef>
                <c:f>(Meshes!$C$9,Meshes!$E$9:$I$9)</c:f>
                <c:numCache>
                  <c:formatCode>General</c:formatCode>
                  <c:ptCount val="6"/>
                  <c:pt idx="0">
                    <c:v>3.1091263510296048</c:v>
                  </c:pt>
                  <c:pt idx="1">
                    <c:v>6.6520673478250352</c:v>
                  </c:pt>
                  <c:pt idx="2">
                    <c:v>5.4772255750516612</c:v>
                  </c:pt>
                  <c:pt idx="3">
                    <c:v>3.5</c:v>
                  </c:pt>
                  <c:pt idx="4">
                    <c:v>4.6904157598234297</c:v>
                  </c:pt>
                  <c:pt idx="5">
                    <c:v>2.75378527364305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Meshes!$C$3,Meshes!$E$3:$I$3)</c:f>
              <c:strCache>
                <c:ptCount val="6"/>
                <c:pt idx="0">
                  <c:v>PBS</c:v>
                </c:pt>
                <c:pt idx="1">
                  <c:v>Exo</c:v>
                </c:pt>
                <c:pt idx="2">
                  <c:v>Exo/anti-miR-Cont</c:v>
                </c:pt>
                <c:pt idx="3">
                  <c:v>Exo/anti-miR-31</c:v>
                </c:pt>
                <c:pt idx="4">
                  <c:v>Exo+Lenti/Cont</c:v>
                </c:pt>
                <c:pt idx="5">
                  <c:v>Exo+Lenti/FIH1</c:v>
                </c:pt>
              </c:strCache>
            </c:strRef>
          </c:cat>
          <c:val>
            <c:numRef>
              <c:f>(Meshes!$C$8,Meshes!$E$8:$I$8)</c:f>
              <c:numCache>
                <c:formatCode>General</c:formatCode>
                <c:ptCount val="6"/>
                <c:pt idx="0">
                  <c:v>8.5</c:v>
                </c:pt>
                <c:pt idx="1">
                  <c:v>27.25</c:v>
                </c:pt>
                <c:pt idx="2">
                  <c:v>25</c:v>
                </c:pt>
                <c:pt idx="3">
                  <c:v>12.75</c:v>
                </c:pt>
                <c:pt idx="4">
                  <c:v>26</c:v>
                </c:pt>
                <c:pt idx="5">
                  <c:v>9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44-7246-A605-5189B496A2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383088"/>
        <c:axId val="1073822656"/>
      </c:barChart>
      <c:catAx>
        <c:axId val="10743830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73822656"/>
        <c:crosses val="autoZero"/>
        <c:auto val="1"/>
        <c:lblAlgn val="ctr"/>
        <c:lblOffset val="100"/>
        <c:noMultiLvlLbl val="0"/>
      </c:catAx>
      <c:valAx>
        <c:axId val="1073822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/>
                  <a:t>Meshes</a:t>
                </a:r>
                <a:r>
                  <a:rPr lang="en-US" b="1" baseline="0"/>
                  <a:t> number</a:t>
                </a:r>
                <a:endParaRPr lang="en-US" b="1"/>
              </a:p>
            </c:rich>
          </c:tx>
          <c:layout>
            <c:manualLayout>
              <c:xMode val="edge"/>
              <c:yMode val="edge"/>
              <c:x val="2.0040182933732876E-2"/>
              <c:y val="5.475484949443298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7438308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3!$C$9,Sheet3!$E$9:$I$9)</c:f>
                <c:numCache>
                  <c:formatCode>General</c:formatCode>
                  <c:ptCount val="6"/>
                  <c:pt idx="0">
                    <c:v>7.4386378681404783E-2</c:v>
                  </c:pt>
                  <c:pt idx="1">
                    <c:v>3.3040379335998349E-2</c:v>
                  </c:pt>
                  <c:pt idx="2">
                    <c:v>2.8867513459481301E-2</c:v>
                  </c:pt>
                  <c:pt idx="3">
                    <c:v>7.4554230821150133E-2</c:v>
                  </c:pt>
                  <c:pt idx="4">
                    <c:v>2.0615528128088177E-2</c:v>
                  </c:pt>
                  <c:pt idx="5">
                    <c:v>5.8523499553598222E-2</c:v>
                  </c:pt>
                </c:numCache>
              </c:numRef>
            </c:plus>
            <c:minus>
              <c:numRef>
                <c:f>(Sheet3!$C$9,Sheet3!$E$9:$I$9)</c:f>
                <c:numCache>
                  <c:formatCode>General</c:formatCode>
                  <c:ptCount val="6"/>
                  <c:pt idx="0">
                    <c:v>7.4386378681404783E-2</c:v>
                  </c:pt>
                  <c:pt idx="1">
                    <c:v>3.3040379335998349E-2</c:v>
                  </c:pt>
                  <c:pt idx="2">
                    <c:v>2.8867513459481301E-2</c:v>
                  </c:pt>
                  <c:pt idx="3">
                    <c:v>7.4554230821150133E-2</c:v>
                  </c:pt>
                  <c:pt idx="4">
                    <c:v>2.0615528128088177E-2</c:v>
                  </c:pt>
                  <c:pt idx="5">
                    <c:v>5.852349955359822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3!$C$3,Sheet3!$E$3,Sheet3!$F$3,Sheet3!$G$3,Sheet3!$H$3,Sheet3!$I$3)</c:f>
              <c:strCache>
                <c:ptCount val="6"/>
                <c:pt idx="0">
                  <c:v>PBS</c:v>
                </c:pt>
                <c:pt idx="1">
                  <c:v>P-MV</c:v>
                </c:pt>
                <c:pt idx="2">
                  <c:v>ZipmiR-Cont</c:v>
                </c:pt>
                <c:pt idx="3">
                  <c:v>ZipmiR-31</c:v>
                </c:pt>
                <c:pt idx="4">
                  <c:v>Lenti-CTL</c:v>
                </c:pt>
                <c:pt idx="5">
                  <c:v>Lenti-FIH</c:v>
                </c:pt>
              </c:strCache>
            </c:strRef>
          </c:cat>
          <c:val>
            <c:numRef>
              <c:f>(Sheet3!$C$8,Sheet3!$E$8,Sheet3!$F$8,Sheet3!$G$8,Sheet3!$H$8,Sheet3!$I$8)</c:f>
              <c:numCache>
                <c:formatCode>General</c:formatCode>
                <c:ptCount val="6"/>
                <c:pt idx="0">
                  <c:v>0.41</c:v>
                </c:pt>
                <c:pt idx="1">
                  <c:v>0.1275</c:v>
                </c:pt>
                <c:pt idx="2">
                  <c:v>0.13500000000000001</c:v>
                </c:pt>
                <c:pt idx="3">
                  <c:v>0.26250000000000001</c:v>
                </c:pt>
                <c:pt idx="4">
                  <c:v>0.13250000000000001</c:v>
                </c:pt>
                <c:pt idx="5">
                  <c:v>0.2824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C6-4830-B6C8-74B596B26D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38062224"/>
        <c:axId val="1037784560"/>
      </c:barChart>
      <c:catAx>
        <c:axId val="1038062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noFill/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37784560"/>
        <c:crosses val="autoZero"/>
        <c:auto val="1"/>
        <c:lblAlgn val="ctr"/>
        <c:lblOffset val="100"/>
        <c:noMultiLvlLbl val="0"/>
      </c:catAx>
      <c:valAx>
        <c:axId val="10377845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b="1" dirty="0"/>
                  <a:t>Lacunarity</a:t>
                </a:r>
              </a:p>
            </c:rich>
          </c:tx>
          <c:layout>
            <c:manualLayout>
              <c:xMode val="edge"/>
              <c:yMode val="edge"/>
              <c:x val="4.0080365867465752E-2"/>
              <c:y val="0.120185156296060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38062224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324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446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06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479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788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219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164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983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9398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48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941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89715-17EC-4ACB-AA84-99E40D08CA59}" type="datetimeFigureOut">
              <a:rPr lang="en-US" smtClean="0"/>
              <a:t>5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B643A-AF04-4D9C-A904-4C2FDE6BFF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957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4" descr="A picture containing text, sign&#10;&#10;Description automatically generated">
            <a:extLst>
              <a:ext uri="{FF2B5EF4-FFF2-40B4-BE49-F238E27FC236}">
                <a16:creationId xmlns:a16="http://schemas.microsoft.com/office/drawing/2014/main" id="{696BE80F-DC44-4A37-B50E-F69EFDA350F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622" t="40301" r="16504" b="35169"/>
          <a:stretch/>
        </p:blipFill>
        <p:spPr>
          <a:xfrm>
            <a:off x="2091789" y="1197142"/>
            <a:ext cx="1393916" cy="530428"/>
          </a:xfrm>
          <a:prstGeom prst="rect">
            <a:avLst/>
          </a:prstGeom>
        </p:spPr>
      </p:pic>
      <p:pic>
        <p:nvPicPr>
          <p:cNvPr id="5" name="Picture 4" descr="A picture containing text, sign, night&#10;&#10;Description automatically generated">
            <a:extLst>
              <a:ext uri="{FF2B5EF4-FFF2-40B4-BE49-F238E27FC236}">
                <a16:creationId xmlns:a16="http://schemas.microsoft.com/office/drawing/2014/main" id="{47F6D2C0-0A3A-4B8F-BCD2-7F5888DA74E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4187" t="40005" r="26576" b="35290"/>
          <a:stretch/>
        </p:blipFill>
        <p:spPr>
          <a:xfrm>
            <a:off x="3548735" y="1197142"/>
            <a:ext cx="1393916" cy="530428"/>
          </a:xfrm>
          <a:prstGeom prst="rect">
            <a:avLst/>
          </a:prstGeom>
        </p:spPr>
      </p:pic>
      <p:pic>
        <p:nvPicPr>
          <p:cNvPr id="6" name="Picture 5" descr="A picture containing text, sign&#10;&#10;Description automatically generated">
            <a:extLst>
              <a:ext uri="{FF2B5EF4-FFF2-40B4-BE49-F238E27FC236}">
                <a16:creationId xmlns:a16="http://schemas.microsoft.com/office/drawing/2014/main" id="{CD76AB4D-0F40-4BB6-AEDC-2AF901671A6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241" t="39888" r="30390" b="35753"/>
          <a:stretch/>
        </p:blipFill>
        <p:spPr>
          <a:xfrm>
            <a:off x="2091789" y="2005933"/>
            <a:ext cx="1393916" cy="530428"/>
          </a:xfrm>
          <a:prstGeom prst="rect">
            <a:avLst/>
          </a:prstGeom>
        </p:spPr>
      </p:pic>
      <p:pic>
        <p:nvPicPr>
          <p:cNvPr id="7" name="Picture 6" descr="A picture containing text, sign&#10;&#10;Description automatically generated">
            <a:extLst>
              <a:ext uri="{FF2B5EF4-FFF2-40B4-BE49-F238E27FC236}">
                <a16:creationId xmlns:a16="http://schemas.microsoft.com/office/drawing/2014/main" id="{CA01DE93-F7FE-4D20-A3D5-081D574F303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9210" t="40153" r="21421" b="35186"/>
          <a:stretch/>
        </p:blipFill>
        <p:spPr>
          <a:xfrm>
            <a:off x="3543468" y="2005933"/>
            <a:ext cx="1393103" cy="53011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5F358CB-F5A9-44FE-819D-274416DC2745}"/>
              </a:ext>
            </a:extLst>
          </p:cNvPr>
          <p:cNvSpPr txBox="1"/>
          <p:nvPr/>
        </p:nvSpPr>
        <p:spPr>
          <a:xfrm>
            <a:off x="2506635" y="964493"/>
            <a:ext cx="5532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A66D25-44F9-4D62-A009-90CBA560827F}"/>
              </a:ext>
            </a:extLst>
          </p:cNvPr>
          <p:cNvSpPr txBox="1"/>
          <p:nvPr/>
        </p:nvSpPr>
        <p:spPr>
          <a:xfrm>
            <a:off x="2182005" y="1783417"/>
            <a:ext cx="12871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Exo/antimiR-Con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C38F03-801A-4E06-A3ED-3CAD19187748}"/>
              </a:ext>
            </a:extLst>
          </p:cNvPr>
          <p:cNvSpPr txBox="1"/>
          <p:nvPr/>
        </p:nvSpPr>
        <p:spPr>
          <a:xfrm>
            <a:off x="4011559" y="968594"/>
            <a:ext cx="50727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C698A7-8CA9-4B32-9CBC-BEA48204DE3F}"/>
              </a:ext>
            </a:extLst>
          </p:cNvPr>
          <p:cNvSpPr txBox="1"/>
          <p:nvPr/>
        </p:nvSpPr>
        <p:spPr>
          <a:xfrm>
            <a:off x="3657781" y="1777385"/>
            <a:ext cx="11726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Exo/antimiR-31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984C6D9-7A02-4180-9AC3-85F8F7DA5E1A}"/>
              </a:ext>
            </a:extLst>
          </p:cNvPr>
          <p:cNvSpPr/>
          <p:nvPr/>
        </p:nvSpPr>
        <p:spPr>
          <a:xfrm>
            <a:off x="481471" y="3180487"/>
            <a:ext cx="586218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sFigure 1.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ea typeface="Arial" panose="020B0604020202020204" pitchFamily="34" charset="0"/>
              </a:rPr>
              <a:t>Exosomes from ASCs promote function recovery in ischemic heart via delivery of miR-31. Mouse myocardial infarction (MI) was induced by permanently ligating the left anterior descending (LAD) coronary artery. PBS, exosomes (Exo) or exosomes from ASCs transduced with anti-miR-Cont (Exo/antimir-Cont) or anti-miR-31 (Exo/antimiR-31) were intramyocardial injected, respectively. Four weeks post-surgery, left ventricular fractional shortening (LVFS) was evaluated with echocardiography. </a:t>
            </a:r>
            <a:endParaRPr lang="en-US" sz="1100"/>
          </a:p>
        </p:txBody>
      </p:sp>
    </p:spTree>
    <p:extLst>
      <p:ext uri="{BB962C8B-B14F-4D97-AF65-F5344CB8AC3E}">
        <p14:creationId xmlns:p14="http://schemas.microsoft.com/office/powerpoint/2010/main" val="20342484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A2EA0E59-0209-4BCC-BF5B-1867FD4D90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23219260"/>
              </p:ext>
            </p:extLst>
          </p:nvPr>
        </p:nvGraphicFramePr>
        <p:xfrm>
          <a:off x="2141843" y="639670"/>
          <a:ext cx="2576524" cy="19354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id="{43A7D139-A6F1-F949-9AC9-FEE29AB104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841338"/>
              </p:ext>
            </p:extLst>
          </p:nvPr>
        </p:nvGraphicFramePr>
        <p:xfrm>
          <a:off x="2258208" y="2183571"/>
          <a:ext cx="2534907" cy="18891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207339A8-1295-4576-8AFF-B090DCDD2D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8494939"/>
              </p:ext>
            </p:extLst>
          </p:nvPr>
        </p:nvGraphicFramePr>
        <p:xfrm>
          <a:off x="2184367" y="3710480"/>
          <a:ext cx="2534907" cy="1916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DF64529-E5D6-4039-A7CF-019656F503C4}"/>
              </a:ext>
            </a:extLst>
          </p:cNvPr>
          <p:cNvSpPr txBox="1"/>
          <p:nvPr/>
        </p:nvSpPr>
        <p:spPr>
          <a:xfrm>
            <a:off x="2976693" y="2203502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EB69D9-8ED5-48D5-950C-E34E4AB0B81F}"/>
              </a:ext>
            </a:extLst>
          </p:cNvPr>
          <p:cNvSpPr txBox="1"/>
          <p:nvPr/>
        </p:nvSpPr>
        <p:spPr>
          <a:xfrm>
            <a:off x="3546752" y="2285830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341ED152-DB0D-4204-AFA9-5DB7A1EB3F88}"/>
              </a:ext>
            </a:extLst>
          </p:cNvPr>
          <p:cNvCxnSpPr>
            <a:cxnSpLocks/>
          </p:cNvCxnSpPr>
          <p:nvPr/>
        </p:nvCxnSpPr>
        <p:spPr>
          <a:xfrm flipH="1">
            <a:off x="2998110" y="2417410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657752D8-C80E-4107-8E9A-643C3314AA21}"/>
              </a:ext>
            </a:extLst>
          </p:cNvPr>
          <p:cNvCxnSpPr>
            <a:cxnSpLocks/>
          </p:cNvCxnSpPr>
          <p:nvPr/>
        </p:nvCxnSpPr>
        <p:spPr>
          <a:xfrm flipH="1">
            <a:off x="3574060" y="2499643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BAF85874-CA9F-4E64-9B99-6B4328A90BCA}"/>
              </a:ext>
            </a:extLst>
          </p:cNvPr>
          <p:cNvCxnSpPr>
            <a:cxnSpLocks/>
          </p:cNvCxnSpPr>
          <p:nvPr/>
        </p:nvCxnSpPr>
        <p:spPr>
          <a:xfrm flipH="1">
            <a:off x="4150558" y="2486289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84D4A846-852D-40C7-8AE4-8CA7182D4545}"/>
              </a:ext>
            </a:extLst>
          </p:cNvPr>
          <p:cNvSpPr txBox="1"/>
          <p:nvPr/>
        </p:nvSpPr>
        <p:spPr>
          <a:xfrm>
            <a:off x="4127225" y="2268582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4BE778-4514-42B4-BEA0-0B2FB17C4DFE}"/>
              </a:ext>
            </a:extLst>
          </p:cNvPr>
          <p:cNvSpPr txBox="1"/>
          <p:nvPr/>
        </p:nvSpPr>
        <p:spPr>
          <a:xfrm>
            <a:off x="2954042" y="520624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8A6A01-D686-46A8-A6A4-0EED831B7D6A}"/>
              </a:ext>
            </a:extLst>
          </p:cNvPr>
          <p:cNvSpPr txBox="1"/>
          <p:nvPr/>
        </p:nvSpPr>
        <p:spPr>
          <a:xfrm>
            <a:off x="4157025" y="617540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C9B1524-D787-4602-A278-B3B644F93E95}"/>
              </a:ext>
            </a:extLst>
          </p:cNvPr>
          <p:cNvCxnSpPr>
            <a:cxnSpLocks/>
          </p:cNvCxnSpPr>
          <p:nvPr/>
        </p:nvCxnSpPr>
        <p:spPr>
          <a:xfrm flipH="1">
            <a:off x="2991713" y="734533"/>
            <a:ext cx="28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FE34CE7-807D-4853-AA23-534B8A40F0C7}"/>
              </a:ext>
            </a:extLst>
          </p:cNvPr>
          <p:cNvCxnSpPr>
            <a:cxnSpLocks/>
          </p:cNvCxnSpPr>
          <p:nvPr/>
        </p:nvCxnSpPr>
        <p:spPr>
          <a:xfrm flipH="1">
            <a:off x="4151127" y="823404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0C834934-0988-4B1A-9016-FD8CE9E6A8F4}"/>
              </a:ext>
            </a:extLst>
          </p:cNvPr>
          <p:cNvCxnSpPr>
            <a:cxnSpLocks/>
          </p:cNvCxnSpPr>
          <p:nvPr/>
        </p:nvCxnSpPr>
        <p:spPr>
          <a:xfrm flipH="1">
            <a:off x="3560309" y="685946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34367D1F-5FCB-415B-8E41-AA3D75B248A6}"/>
              </a:ext>
            </a:extLst>
          </p:cNvPr>
          <p:cNvSpPr txBox="1"/>
          <p:nvPr/>
        </p:nvSpPr>
        <p:spPr>
          <a:xfrm>
            <a:off x="3585469" y="46028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0AA21B-2F61-420C-986C-C35C69B3BB4B}"/>
              </a:ext>
            </a:extLst>
          </p:cNvPr>
          <p:cNvSpPr txBox="1"/>
          <p:nvPr/>
        </p:nvSpPr>
        <p:spPr>
          <a:xfrm>
            <a:off x="2978983" y="3701029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9D3A50B-487F-48C2-A9B8-3A37C9911D38}"/>
              </a:ext>
            </a:extLst>
          </p:cNvPr>
          <p:cNvSpPr txBox="1"/>
          <p:nvPr/>
        </p:nvSpPr>
        <p:spPr>
          <a:xfrm>
            <a:off x="4154669" y="3940692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E09B8DB-C447-45FF-A5CB-23844FF103C6}"/>
              </a:ext>
            </a:extLst>
          </p:cNvPr>
          <p:cNvCxnSpPr>
            <a:cxnSpLocks/>
          </p:cNvCxnSpPr>
          <p:nvPr/>
        </p:nvCxnSpPr>
        <p:spPr>
          <a:xfrm flipH="1">
            <a:off x="2997309" y="3914939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B188476F-6AAE-4A3B-AFA9-9C5C7C2986A1}"/>
              </a:ext>
            </a:extLst>
          </p:cNvPr>
          <p:cNvCxnSpPr>
            <a:cxnSpLocks/>
          </p:cNvCxnSpPr>
          <p:nvPr/>
        </p:nvCxnSpPr>
        <p:spPr>
          <a:xfrm flipH="1">
            <a:off x="4140889" y="4154507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F499F7F-4AFD-4254-9083-6182E4C14D7B}"/>
              </a:ext>
            </a:extLst>
          </p:cNvPr>
          <p:cNvCxnSpPr>
            <a:cxnSpLocks/>
          </p:cNvCxnSpPr>
          <p:nvPr/>
        </p:nvCxnSpPr>
        <p:spPr>
          <a:xfrm flipH="1">
            <a:off x="3567753" y="4154907"/>
            <a:ext cx="2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293575F4-B179-4602-95BF-23587A48BE0F}"/>
              </a:ext>
            </a:extLst>
          </p:cNvPr>
          <p:cNvSpPr txBox="1"/>
          <p:nvPr/>
        </p:nvSpPr>
        <p:spPr>
          <a:xfrm>
            <a:off x="3586169" y="3945153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1E40F3A-A755-4533-8ACE-4E3CCD3E160D}"/>
              </a:ext>
            </a:extLst>
          </p:cNvPr>
          <p:cNvSpPr txBox="1"/>
          <p:nvPr/>
        </p:nvSpPr>
        <p:spPr>
          <a:xfrm>
            <a:off x="2035945" y="450673"/>
            <a:ext cx="3698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763B8BD-0C1F-45A4-9313-E174CB0F5796}"/>
              </a:ext>
            </a:extLst>
          </p:cNvPr>
          <p:cNvSpPr txBox="1"/>
          <p:nvPr/>
        </p:nvSpPr>
        <p:spPr>
          <a:xfrm>
            <a:off x="2026093" y="1947839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D49CFFF-DF2D-436D-839A-BD5FFCFCA894}"/>
              </a:ext>
            </a:extLst>
          </p:cNvPr>
          <p:cNvSpPr txBox="1"/>
          <p:nvPr/>
        </p:nvSpPr>
        <p:spPr>
          <a:xfrm>
            <a:off x="2037668" y="3546939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7860E34D-4A16-4530-A7BC-2519A2E69DF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9038" t="55950" r="8524" b="3891"/>
          <a:stretch/>
        </p:blipFill>
        <p:spPr>
          <a:xfrm>
            <a:off x="2782187" y="4792670"/>
            <a:ext cx="1736356" cy="775108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CCEBF5CF-DC9B-465F-A833-35F17C25DC8B}"/>
              </a:ext>
            </a:extLst>
          </p:cNvPr>
          <p:cNvSpPr/>
          <p:nvPr/>
        </p:nvSpPr>
        <p:spPr>
          <a:xfrm>
            <a:off x="596348" y="5751373"/>
            <a:ext cx="562952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r>
              <a:rPr lang="en-US" sz="1100" dirty="0">
                <a:latin typeface="Arial" panose="020B0604020202020204" pitchFamily="34" charset="0"/>
                <a:ea typeface="SimSun" panose="02010600030101010101" pitchFamily="2" charset="-122"/>
              </a:rPr>
              <a:t>Exosomal miR-31 promotes tube formation of HMCECs via suppressing FIH1.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Arial Unicode MS" panose="020B0604020202020204" pitchFamily="34" charset="-128"/>
              </a:rPr>
              <a:t>HMVECs were treated with Exo, Exo/anti-miR-31, or Exo plus lentiviral FIH-1 (</a:t>
            </a:r>
            <a:r>
              <a:rPr lang="en-US" sz="1100" dirty="0" err="1">
                <a:latin typeface="Arial" panose="020B0604020202020204" pitchFamily="34" charset="0"/>
                <a:ea typeface="Arial Unicode MS" panose="020B0604020202020204" pitchFamily="34" charset="-128"/>
              </a:rPr>
              <a:t>Exo+Lenti</a:t>
            </a:r>
            <a:r>
              <a:rPr lang="en-US" altLang="zh-CN" sz="1100" dirty="0">
                <a:latin typeface="Arial" panose="020B0604020202020204" pitchFamily="34" charset="0"/>
                <a:ea typeface="Arial Unicode MS" panose="020B0604020202020204" pitchFamily="34" charset="-128"/>
              </a:rPr>
              <a:t>/</a:t>
            </a:r>
            <a:r>
              <a:rPr lang="en-US" sz="1100" dirty="0">
                <a:latin typeface="Arial" panose="020B0604020202020204" pitchFamily="34" charset="0"/>
                <a:ea typeface="Arial Unicode MS" panose="020B0604020202020204" pitchFamily="34" charset="-128"/>
              </a:rPr>
              <a:t>FIH1). PBS, Exo/</a:t>
            </a:r>
            <a:r>
              <a:rPr lang="en-US" sz="1100" dirty="0" err="1">
                <a:latin typeface="Arial" panose="020B0604020202020204" pitchFamily="34" charset="0"/>
                <a:ea typeface="Arial Unicode MS" panose="020B0604020202020204" pitchFamily="34" charset="-128"/>
              </a:rPr>
              <a:t>antimiR</a:t>
            </a:r>
            <a:r>
              <a:rPr lang="en-US" sz="1100" dirty="0">
                <a:latin typeface="Arial" panose="020B0604020202020204" pitchFamily="34" charset="0"/>
                <a:ea typeface="Arial Unicode MS" panose="020B0604020202020204" pitchFamily="34" charset="-128"/>
              </a:rPr>
              <a:t>-Cont, or </a:t>
            </a:r>
            <a:r>
              <a:rPr lang="en-US" sz="1100" dirty="0" err="1">
                <a:latin typeface="Arial" panose="020B0604020202020204" pitchFamily="34" charset="0"/>
                <a:ea typeface="Arial Unicode MS" panose="020B0604020202020204" pitchFamily="34" charset="-128"/>
              </a:rPr>
              <a:t>Exo+Lenti</a:t>
            </a:r>
            <a:r>
              <a:rPr lang="en-US" altLang="zh-CN" sz="1100" dirty="0">
                <a:latin typeface="Arial" panose="020B0604020202020204" pitchFamily="34" charset="0"/>
                <a:ea typeface="Arial Unicode MS" panose="020B0604020202020204" pitchFamily="34" charset="-128"/>
              </a:rPr>
              <a:t>/</a:t>
            </a:r>
            <a:r>
              <a:rPr lang="en-US" sz="1100" dirty="0">
                <a:latin typeface="Arial" panose="020B0604020202020204" pitchFamily="34" charset="0"/>
                <a:ea typeface="Arial Unicode MS" panose="020B0604020202020204" pitchFamily="34" charset="-128"/>
              </a:rPr>
              <a:t>Cont was used as a control, respectively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Cell tube formation assays of the HMVECs were performed and t</a:t>
            </a:r>
            <a:r>
              <a:rPr lang="en-US" sz="1100" dirty="0">
                <a:latin typeface="Arial"/>
                <a:cs typeface="Arial"/>
              </a:rPr>
              <a:t>he total number of junctions (A),  meshes number (B), and lacunarity (C) were measured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 described in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the Materials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Methods.</a:t>
            </a:r>
            <a:r>
              <a:rPr lang="en-US" sz="1100" dirty="0">
                <a:solidFill>
                  <a:srgbClr val="000000"/>
                </a:solidFill>
                <a:latin typeface="Arial"/>
                <a:ea typeface="Times New Roman" panose="02020603050405020304" pitchFamily="18" charset="0"/>
                <a:cs typeface="Arial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*</a:t>
            </a:r>
            <a:r>
              <a:rPr lang="en-US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&lt;0.05 and **</a:t>
            </a:r>
            <a:r>
              <a:rPr lang="en-US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</a:rPr>
              <a:t>&lt;0.01.</a:t>
            </a:r>
            <a:endParaRPr lang="en-US" sz="11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057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E66352F-0244-45C3-AE35-B4F02B1DB187}"/>
              </a:ext>
            </a:extLst>
          </p:cNvPr>
          <p:cNvSpPr txBox="1"/>
          <p:nvPr/>
        </p:nvSpPr>
        <p:spPr>
          <a:xfrm>
            <a:off x="1415192" y="1829744"/>
            <a:ext cx="8290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IB: HIF-1α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DCE3546-07F4-4B5F-8F06-336B04FD8428}"/>
              </a:ext>
            </a:extLst>
          </p:cNvPr>
          <p:cNvSpPr txBox="1"/>
          <p:nvPr/>
        </p:nvSpPr>
        <p:spPr>
          <a:xfrm>
            <a:off x="4425538" y="1823661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120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B49AA66-C0DF-4D2E-A9D2-FEC586E51039}"/>
              </a:ext>
            </a:extLst>
          </p:cNvPr>
          <p:cNvSpPr txBox="1"/>
          <p:nvPr/>
        </p:nvSpPr>
        <p:spPr>
          <a:xfrm>
            <a:off x="3848728" y="1163769"/>
            <a:ext cx="356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511AA96-9BFF-49E7-BC91-3ECDA1C0E8FE}"/>
              </a:ext>
            </a:extLst>
          </p:cNvPr>
          <p:cNvSpPr txBox="1"/>
          <p:nvPr/>
        </p:nvSpPr>
        <p:spPr>
          <a:xfrm>
            <a:off x="2259492" y="1425380"/>
            <a:ext cx="4972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38A89AA-0FF3-44DC-89F8-69B3C9C9F84E}"/>
              </a:ext>
            </a:extLst>
          </p:cNvPr>
          <p:cNvSpPr txBox="1"/>
          <p:nvPr/>
        </p:nvSpPr>
        <p:spPr>
          <a:xfrm>
            <a:off x="2885328" y="1430629"/>
            <a:ext cx="585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EFBA53D-17C2-4685-8514-838EE362668C}"/>
              </a:ext>
            </a:extLst>
          </p:cNvPr>
          <p:cNvSpPr txBox="1"/>
          <p:nvPr/>
        </p:nvSpPr>
        <p:spPr>
          <a:xfrm>
            <a:off x="3504578" y="1425380"/>
            <a:ext cx="4106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0B09761-C341-4C1F-AB66-99DFE798928A}"/>
              </a:ext>
            </a:extLst>
          </p:cNvPr>
          <p:cNvSpPr txBox="1"/>
          <p:nvPr/>
        </p:nvSpPr>
        <p:spPr>
          <a:xfrm>
            <a:off x="3959890" y="1425380"/>
            <a:ext cx="4988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p300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93366E6-9FF2-437A-9BB0-BFB3339C5F78}"/>
              </a:ext>
            </a:extLst>
          </p:cNvPr>
          <p:cNvCxnSpPr/>
          <p:nvPr/>
        </p:nvCxnSpPr>
        <p:spPr>
          <a:xfrm>
            <a:off x="3620188" y="1393285"/>
            <a:ext cx="756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2C3CEEE6-2046-4063-A982-FBFEDA7C28B7}"/>
              </a:ext>
            </a:extLst>
          </p:cNvPr>
          <p:cNvSpPr/>
          <p:nvPr/>
        </p:nvSpPr>
        <p:spPr>
          <a:xfrm>
            <a:off x="656697" y="2900837"/>
            <a:ext cx="5553603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Figure 3 .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-immunoprecipitation (Co-IP) analysis of 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p300-bound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HIF1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α in HMVECs.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Pre-cleared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HMVEC nuclear lysate (Input) was incubated with anti-p300 antibody and subsequently precipitated with protein A magnetic beads. Normal IgG was used parallelly as an isotype control of anti-p300 antibody. Beads stand for the magnificent beads incubated with the anti-p300 antibody without input.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Immunoblotting</a:t>
            </a:r>
            <a:r>
              <a:rPr lang="zh-CN" altLang="en-US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CN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(IB)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analysis of HIF1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 levels was performed for the various samples. </a:t>
            </a:r>
            <a:endParaRPr lang="en-US" sz="1100">
              <a:solidFill>
                <a:srgbClr val="000000"/>
              </a:solidFill>
              <a:latin typeface="Arial" panose="020B0604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Picture 12" descr="Shape&#10;&#10;Description automatically generated">
            <a:extLst>
              <a:ext uri="{FF2B5EF4-FFF2-40B4-BE49-F238E27FC236}">
                <a16:creationId xmlns:a16="http://schemas.microsoft.com/office/drawing/2014/main" id="{21EF0E44-30FF-D146-8F24-2AFF252A61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4033" y="1719084"/>
            <a:ext cx="2161505" cy="525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93327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BFF5D1-DA75-6445-9C17-DE9B4077D47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87" t="10989" r="12322" b="17770"/>
          <a:stretch/>
        </p:blipFill>
        <p:spPr>
          <a:xfrm flipH="1">
            <a:off x="1772290" y="451898"/>
            <a:ext cx="2541795" cy="660479"/>
          </a:xfrm>
          <a:prstGeom prst="rect">
            <a:avLst/>
          </a:prstGeom>
        </p:spPr>
      </p:pic>
      <p:pic>
        <p:nvPicPr>
          <p:cNvPr id="6" name="Picture 5" descr="A picture containing text, indoor, close&#10;&#10;Description automatically generated">
            <a:extLst>
              <a:ext uri="{FF2B5EF4-FFF2-40B4-BE49-F238E27FC236}">
                <a16:creationId xmlns:a16="http://schemas.microsoft.com/office/drawing/2014/main" id="{E9428EF5-FA96-B749-8EE7-B6AE2922943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72" r="11841" b="9589"/>
          <a:stretch/>
        </p:blipFill>
        <p:spPr>
          <a:xfrm flipH="1">
            <a:off x="1772289" y="1295368"/>
            <a:ext cx="2541795" cy="838200"/>
          </a:xfrm>
          <a:prstGeom prst="rect">
            <a:avLst/>
          </a:prstGeom>
        </p:spPr>
      </p:pic>
      <p:pic>
        <p:nvPicPr>
          <p:cNvPr id="10" name="Picture 9" descr="A picture containing close, distance&#10;&#10;Description automatically generated">
            <a:extLst>
              <a:ext uri="{FF2B5EF4-FFF2-40B4-BE49-F238E27FC236}">
                <a16:creationId xmlns:a16="http://schemas.microsoft.com/office/drawing/2014/main" id="{6116FA48-93B6-4344-9B34-F3CEB4189AB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2289" y="2460909"/>
            <a:ext cx="2641265" cy="934769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EC1E1C10-E9F1-7341-BB46-890821FE3701}"/>
              </a:ext>
            </a:extLst>
          </p:cNvPr>
          <p:cNvSpPr/>
          <p:nvPr/>
        </p:nvSpPr>
        <p:spPr>
          <a:xfrm>
            <a:off x="3597639" y="801974"/>
            <a:ext cx="412230" cy="26225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28BFDF4D-F3D6-BA48-A108-685EAB1FFCD1}"/>
              </a:ext>
            </a:extLst>
          </p:cNvPr>
          <p:cNvSpPr/>
          <p:nvPr/>
        </p:nvSpPr>
        <p:spPr>
          <a:xfrm>
            <a:off x="3698822" y="1702483"/>
            <a:ext cx="444709" cy="23984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323FE99-9D25-7C4B-BC13-C3901861EE06}"/>
              </a:ext>
            </a:extLst>
          </p:cNvPr>
          <p:cNvSpPr/>
          <p:nvPr/>
        </p:nvSpPr>
        <p:spPr>
          <a:xfrm>
            <a:off x="2094492" y="2920145"/>
            <a:ext cx="1839692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76379F2A-2D72-AC42-B32A-6B613CA0DC0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5" t="909" r="14156" b="-909"/>
          <a:stretch/>
        </p:blipFill>
        <p:spPr>
          <a:xfrm>
            <a:off x="1772289" y="3816926"/>
            <a:ext cx="2641266" cy="967377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6083B641-A0B2-7546-A65C-D7AB6D6A4C8B}"/>
              </a:ext>
            </a:extLst>
          </p:cNvPr>
          <p:cNvSpPr/>
          <p:nvPr/>
        </p:nvSpPr>
        <p:spPr>
          <a:xfrm>
            <a:off x="2177505" y="4220240"/>
            <a:ext cx="1817671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0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EBA3E53-F2FD-8F4B-967E-621B61BE624E}"/>
              </a:ext>
            </a:extLst>
          </p:cNvPr>
          <p:cNvSpPr txBox="1"/>
          <p:nvPr/>
        </p:nvSpPr>
        <p:spPr>
          <a:xfrm>
            <a:off x="1293775" y="651332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CD9</a:t>
            </a:r>
            <a:endParaRPr 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4953206-215D-3449-A528-1A77403FF871}"/>
              </a:ext>
            </a:extLst>
          </p:cNvPr>
          <p:cNvSpPr txBox="1"/>
          <p:nvPr/>
        </p:nvSpPr>
        <p:spPr>
          <a:xfrm>
            <a:off x="1007759" y="1680716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TSG-101</a:t>
            </a:r>
            <a:endParaRPr 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D16045E-09CD-434D-A422-826260D26C6D}"/>
              </a:ext>
            </a:extLst>
          </p:cNvPr>
          <p:cNvSpPr txBox="1"/>
          <p:nvPr/>
        </p:nvSpPr>
        <p:spPr>
          <a:xfrm>
            <a:off x="4308783" y="787073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42 K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72FDE99-F3ED-A344-9AF3-BA82438B18DE}"/>
              </a:ext>
            </a:extLst>
          </p:cNvPr>
          <p:cNvSpPr txBox="1"/>
          <p:nvPr/>
        </p:nvSpPr>
        <p:spPr>
          <a:xfrm>
            <a:off x="4290935" y="1722465"/>
            <a:ext cx="57740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46 K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D7928A7-1951-8647-9A0F-F7C7E8A678F9}"/>
              </a:ext>
            </a:extLst>
          </p:cNvPr>
          <p:cNvSpPr txBox="1"/>
          <p:nvPr/>
        </p:nvSpPr>
        <p:spPr>
          <a:xfrm>
            <a:off x="570500" y="8256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 1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0462C25-4C71-2547-9075-6E0BA4DDD37A}"/>
              </a:ext>
            </a:extLst>
          </p:cNvPr>
          <p:cNvSpPr txBox="1"/>
          <p:nvPr/>
        </p:nvSpPr>
        <p:spPr>
          <a:xfrm>
            <a:off x="1295681" y="2964805"/>
            <a:ext cx="545910" cy="23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35">
                <a:latin typeface="Arial" panose="020B0604020202020204" pitchFamily="34" charset="0"/>
                <a:cs typeface="Arial" panose="020B0604020202020204" pitchFamily="34" charset="0"/>
              </a:rPr>
              <a:t>FIH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D8DBEB3-DA39-B144-BF8B-F6D20CF43C33}"/>
              </a:ext>
            </a:extLst>
          </p:cNvPr>
          <p:cNvSpPr txBox="1"/>
          <p:nvPr/>
        </p:nvSpPr>
        <p:spPr>
          <a:xfrm>
            <a:off x="1134204" y="4256920"/>
            <a:ext cx="663153" cy="23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35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D67D62D-E3D0-B24E-9E0D-14B73DAD4C26}"/>
              </a:ext>
            </a:extLst>
          </p:cNvPr>
          <p:cNvSpPr txBox="1"/>
          <p:nvPr/>
        </p:nvSpPr>
        <p:spPr>
          <a:xfrm>
            <a:off x="4397259" y="2926385"/>
            <a:ext cx="6425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40 KD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7D63779-DB42-E349-B366-90AE744584F8}"/>
              </a:ext>
            </a:extLst>
          </p:cNvPr>
          <p:cNvSpPr txBox="1"/>
          <p:nvPr/>
        </p:nvSpPr>
        <p:spPr>
          <a:xfrm>
            <a:off x="4397259" y="4244225"/>
            <a:ext cx="6425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37 K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D3936F5-35B2-3846-A1C4-B4774EAE5095}"/>
              </a:ext>
            </a:extLst>
          </p:cNvPr>
          <p:cNvSpPr txBox="1"/>
          <p:nvPr/>
        </p:nvSpPr>
        <p:spPr>
          <a:xfrm>
            <a:off x="637987" y="2301606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 5A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2C68F28-0CA3-6E4C-87E0-7681C0D79748}"/>
              </a:ext>
            </a:extLst>
          </p:cNvPr>
          <p:cNvSpPr txBox="1"/>
          <p:nvPr/>
        </p:nvSpPr>
        <p:spPr>
          <a:xfrm rot="18688152">
            <a:off x="3502338" y="527133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BFAE917-2394-B245-9385-3BFE153A6E15}"/>
              </a:ext>
            </a:extLst>
          </p:cNvPr>
          <p:cNvSpPr txBox="1"/>
          <p:nvPr/>
        </p:nvSpPr>
        <p:spPr>
          <a:xfrm rot="18642606">
            <a:off x="3748121" y="58722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E171F799-A1C1-894C-AA3E-BFD49E1A2EE4}"/>
              </a:ext>
            </a:extLst>
          </p:cNvPr>
          <p:cNvSpPr txBox="1"/>
          <p:nvPr/>
        </p:nvSpPr>
        <p:spPr>
          <a:xfrm rot="18402718">
            <a:off x="3338125" y="2501934"/>
            <a:ext cx="828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enti/Cont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82FB918-26C9-6747-8820-056146A082A1}"/>
              </a:ext>
            </a:extLst>
          </p:cNvPr>
          <p:cNvSpPr txBox="1"/>
          <p:nvPr/>
        </p:nvSpPr>
        <p:spPr>
          <a:xfrm rot="18455813">
            <a:off x="3528951" y="2502683"/>
            <a:ext cx="819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err="1"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/FIH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F184D3B-62AF-254C-8571-D3104BDFACE7}"/>
              </a:ext>
            </a:extLst>
          </p:cNvPr>
          <p:cNvSpPr txBox="1"/>
          <p:nvPr/>
        </p:nvSpPr>
        <p:spPr>
          <a:xfrm rot="18402718">
            <a:off x="2821184" y="2353199"/>
            <a:ext cx="12025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Exo/</a:t>
            </a:r>
            <a:r>
              <a:rPr lang="en-US" sz="900" err="1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-Cont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0BE20EC-182B-F648-AABC-E1B8940600A5}"/>
              </a:ext>
            </a:extLst>
          </p:cNvPr>
          <p:cNvSpPr txBox="1"/>
          <p:nvPr/>
        </p:nvSpPr>
        <p:spPr>
          <a:xfrm rot="18402718">
            <a:off x="3082274" y="2412044"/>
            <a:ext cx="1077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Exo/antimiR-3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04C6965C-853F-AB4E-9058-F986202D5A5A}"/>
              </a:ext>
            </a:extLst>
          </p:cNvPr>
          <p:cNvSpPr txBox="1"/>
          <p:nvPr/>
        </p:nvSpPr>
        <p:spPr>
          <a:xfrm rot="18402718">
            <a:off x="2586827" y="2347158"/>
            <a:ext cx="12025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re-miR-3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EF3F814F-6222-5D44-BE29-CD4B2BE0C102}"/>
              </a:ext>
            </a:extLst>
          </p:cNvPr>
          <p:cNvSpPr txBox="1"/>
          <p:nvPr/>
        </p:nvSpPr>
        <p:spPr>
          <a:xfrm rot="18402718">
            <a:off x="2422758" y="2434529"/>
            <a:ext cx="9212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sz="90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-Cont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1F2AC1F-F40C-2C42-90D6-71406748A4B7}"/>
              </a:ext>
            </a:extLst>
          </p:cNvPr>
          <p:cNvSpPr txBox="1"/>
          <p:nvPr/>
        </p:nvSpPr>
        <p:spPr>
          <a:xfrm rot="18402718">
            <a:off x="2318107" y="2656026"/>
            <a:ext cx="4507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182028A-CA6C-724A-84CF-E33EEA4AEA28}"/>
              </a:ext>
            </a:extLst>
          </p:cNvPr>
          <p:cNvSpPr txBox="1"/>
          <p:nvPr/>
        </p:nvSpPr>
        <p:spPr>
          <a:xfrm rot="18402718">
            <a:off x="2035446" y="2660381"/>
            <a:ext cx="440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62EADAF-8F79-FA47-BB46-D7AD5F5722C2}"/>
              </a:ext>
            </a:extLst>
          </p:cNvPr>
          <p:cNvSpPr txBox="1"/>
          <p:nvPr/>
        </p:nvSpPr>
        <p:spPr>
          <a:xfrm rot="18688152">
            <a:off x="3616299" y="1272703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FB1914CF-D14E-234C-99FC-A41A8C8461E9}"/>
              </a:ext>
            </a:extLst>
          </p:cNvPr>
          <p:cNvSpPr txBox="1"/>
          <p:nvPr/>
        </p:nvSpPr>
        <p:spPr>
          <a:xfrm rot="18642606">
            <a:off x="3862082" y="1332799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1249EA3-0035-A24D-9997-63CFD22AFA6A}"/>
              </a:ext>
            </a:extLst>
          </p:cNvPr>
          <p:cNvSpPr txBox="1"/>
          <p:nvPr/>
        </p:nvSpPr>
        <p:spPr>
          <a:xfrm rot="18402718">
            <a:off x="3399518" y="3821485"/>
            <a:ext cx="828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Lenti/Cont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378A907-187E-E64E-93E9-F235ED1F2956}"/>
              </a:ext>
            </a:extLst>
          </p:cNvPr>
          <p:cNvSpPr txBox="1"/>
          <p:nvPr/>
        </p:nvSpPr>
        <p:spPr>
          <a:xfrm rot="18455813">
            <a:off x="3590344" y="3822234"/>
            <a:ext cx="8195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err="1"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/FIH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F6B8D4DC-BFB8-E84C-B962-D5F4A5306801}"/>
              </a:ext>
            </a:extLst>
          </p:cNvPr>
          <p:cNvSpPr txBox="1"/>
          <p:nvPr/>
        </p:nvSpPr>
        <p:spPr>
          <a:xfrm rot="18402718">
            <a:off x="2882577" y="3672750"/>
            <a:ext cx="12025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Exo/</a:t>
            </a:r>
            <a:r>
              <a:rPr lang="en-US" sz="900" err="1">
                <a:latin typeface="Arial" panose="020B0604020202020204" pitchFamily="34" charset="0"/>
                <a:cs typeface="Arial" panose="020B0604020202020204" pitchFamily="34" charset="0"/>
              </a:rPr>
              <a:t>antimiR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-Cont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825C053-B2A5-9649-AF0E-393A5B07F289}"/>
              </a:ext>
            </a:extLst>
          </p:cNvPr>
          <p:cNvSpPr txBox="1"/>
          <p:nvPr/>
        </p:nvSpPr>
        <p:spPr>
          <a:xfrm rot="18402718">
            <a:off x="2648220" y="3666709"/>
            <a:ext cx="120250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re-miR-3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3F21031-B493-AE44-81C2-278B4DD0CBB4}"/>
              </a:ext>
            </a:extLst>
          </p:cNvPr>
          <p:cNvSpPr txBox="1"/>
          <p:nvPr/>
        </p:nvSpPr>
        <p:spPr>
          <a:xfrm rot="18402718">
            <a:off x="2484151" y="3754080"/>
            <a:ext cx="9212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re-</a:t>
            </a:r>
            <a:r>
              <a:rPr lang="en-US" sz="90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-Cont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5B66DB07-6332-AF4F-A380-D77930E8795A}"/>
              </a:ext>
            </a:extLst>
          </p:cNvPr>
          <p:cNvSpPr txBox="1"/>
          <p:nvPr/>
        </p:nvSpPr>
        <p:spPr>
          <a:xfrm rot="18402718">
            <a:off x="2379500" y="3975577"/>
            <a:ext cx="4507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Exo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004549A-37E6-894F-9954-CDF41F389789}"/>
              </a:ext>
            </a:extLst>
          </p:cNvPr>
          <p:cNvSpPr txBox="1"/>
          <p:nvPr/>
        </p:nvSpPr>
        <p:spPr>
          <a:xfrm rot="18402718">
            <a:off x="2096839" y="3979932"/>
            <a:ext cx="4404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CBC12B02-D8D6-764A-9ECE-DDD25A5B40DE}"/>
              </a:ext>
            </a:extLst>
          </p:cNvPr>
          <p:cNvSpPr txBox="1"/>
          <p:nvPr/>
        </p:nvSpPr>
        <p:spPr>
          <a:xfrm rot="18402718">
            <a:off x="3137412" y="3716902"/>
            <a:ext cx="10772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>
                <a:latin typeface="Arial" panose="020B0604020202020204" pitchFamily="34" charset="0"/>
                <a:cs typeface="Arial" panose="020B0604020202020204" pitchFamily="34" charset="0"/>
              </a:rPr>
              <a:t>Exo/antimiR-31</a:t>
            </a:r>
          </a:p>
        </p:txBody>
      </p:sp>
    </p:spTree>
    <p:extLst>
      <p:ext uri="{BB962C8B-B14F-4D97-AF65-F5344CB8AC3E}">
        <p14:creationId xmlns:p14="http://schemas.microsoft.com/office/powerpoint/2010/main" val="9229334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7DD172D-A228-ED48-A37F-393F2D56BC4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5" r="-653"/>
          <a:stretch/>
        </p:blipFill>
        <p:spPr>
          <a:xfrm>
            <a:off x="2032654" y="700019"/>
            <a:ext cx="2188686" cy="7747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0B05961-9BA3-7E4E-8448-87246559095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8" t="16398"/>
          <a:stretch/>
        </p:blipFill>
        <p:spPr>
          <a:xfrm>
            <a:off x="1970075" y="3133413"/>
            <a:ext cx="3356384" cy="934333"/>
          </a:xfrm>
          <a:prstGeom prst="rect">
            <a:avLst/>
          </a:prstGeom>
        </p:spPr>
      </p:pic>
      <p:pic>
        <p:nvPicPr>
          <p:cNvPr id="4" name="Picture 3" descr="A picture containing kitchen appliance&#10;&#10;Description automatically generated">
            <a:extLst>
              <a:ext uri="{FF2B5EF4-FFF2-40B4-BE49-F238E27FC236}">
                <a16:creationId xmlns:a16="http://schemas.microsoft.com/office/drawing/2014/main" id="{2F925056-6CEF-2A4E-8A43-CFE93A07E8B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9" t="9590" r="8680" b="14895"/>
          <a:stretch/>
        </p:blipFill>
        <p:spPr>
          <a:xfrm>
            <a:off x="2004329" y="1978411"/>
            <a:ext cx="2188687" cy="774700"/>
          </a:xfrm>
          <a:prstGeom prst="rect">
            <a:avLst/>
          </a:prstGeom>
        </p:spPr>
      </p:pic>
      <p:pic>
        <p:nvPicPr>
          <p:cNvPr id="5" name="Picture 4" descr="Shape&#10;&#10;Description automatically generated">
            <a:extLst>
              <a:ext uri="{FF2B5EF4-FFF2-40B4-BE49-F238E27FC236}">
                <a16:creationId xmlns:a16="http://schemas.microsoft.com/office/drawing/2014/main" id="{5ACA8A28-A3DF-A84B-9AD7-AD1E5FF062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6" r="6492"/>
          <a:stretch/>
        </p:blipFill>
        <p:spPr>
          <a:xfrm>
            <a:off x="1963579" y="4650793"/>
            <a:ext cx="3356384" cy="8890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3403E06-24B9-D345-B824-94D196FB008F}"/>
              </a:ext>
            </a:extLst>
          </p:cNvPr>
          <p:cNvSpPr/>
          <p:nvPr/>
        </p:nvSpPr>
        <p:spPr>
          <a:xfrm>
            <a:off x="2206760" y="924668"/>
            <a:ext cx="856755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38BE40C-088B-6A41-A9C9-10343D17DD54}"/>
              </a:ext>
            </a:extLst>
          </p:cNvPr>
          <p:cNvSpPr/>
          <p:nvPr/>
        </p:nvSpPr>
        <p:spPr>
          <a:xfrm>
            <a:off x="3078507" y="924668"/>
            <a:ext cx="856755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10274AA-F6C7-7C47-843E-3F210E040DBA}"/>
              </a:ext>
            </a:extLst>
          </p:cNvPr>
          <p:cNvSpPr/>
          <p:nvPr/>
        </p:nvSpPr>
        <p:spPr>
          <a:xfrm>
            <a:off x="2174357" y="2231886"/>
            <a:ext cx="856755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2D5B6529-888B-BB4C-961E-19F0255AEC28}"/>
              </a:ext>
            </a:extLst>
          </p:cNvPr>
          <p:cNvSpPr/>
          <p:nvPr/>
        </p:nvSpPr>
        <p:spPr>
          <a:xfrm>
            <a:off x="3050181" y="2230272"/>
            <a:ext cx="856755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82D9295-1B50-FE4F-9E45-7F6B5E2A2323}"/>
              </a:ext>
            </a:extLst>
          </p:cNvPr>
          <p:cNvSpPr/>
          <p:nvPr/>
        </p:nvSpPr>
        <p:spPr>
          <a:xfrm>
            <a:off x="2223560" y="3502964"/>
            <a:ext cx="790111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954DB55-C613-0745-BF1F-A9775DDDC774}"/>
              </a:ext>
            </a:extLst>
          </p:cNvPr>
          <p:cNvSpPr/>
          <p:nvPr/>
        </p:nvSpPr>
        <p:spPr>
          <a:xfrm>
            <a:off x="3025856" y="3502167"/>
            <a:ext cx="790111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4ACD79C7-0532-194A-8770-2C97901755C0}"/>
              </a:ext>
            </a:extLst>
          </p:cNvPr>
          <p:cNvSpPr/>
          <p:nvPr/>
        </p:nvSpPr>
        <p:spPr>
          <a:xfrm>
            <a:off x="2224138" y="4837043"/>
            <a:ext cx="779491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E040896-A5E4-5A40-A051-10AAD8DB8E7C}"/>
              </a:ext>
            </a:extLst>
          </p:cNvPr>
          <p:cNvSpPr/>
          <p:nvPr/>
        </p:nvSpPr>
        <p:spPr>
          <a:xfrm>
            <a:off x="3018705" y="4835429"/>
            <a:ext cx="794449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7AC9168-72AC-8946-8981-73FFD6244FE2}"/>
              </a:ext>
            </a:extLst>
          </p:cNvPr>
          <p:cNvSpPr txBox="1"/>
          <p:nvPr/>
        </p:nvSpPr>
        <p:spPr>
          <a:xfrm>
            <a:off x="998896" y="3529732"/>
            <a:ext cx="920124" cy="27186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HIF-1</a:t>
            </a:r>
            <a:r>
              <a:rPr kumimoji="0" lang="el-GR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α</a:t>
            </a: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 (Pan)</a:t>
            </a:r>
            <a:endParaRPr kumimoji="0" lang="en-US" sz="1100" b="0" i="0" u="none" strike="noStrike" cap="none" spc="0" normalizeH="0" baseline="0">
              <a:ln>
                <a:noFill/>
              </a:ln>
              <a:solidFill>
                <a:schemeClr val="tx2">
                  <a:lumMod val="50000"/>
                </a:schemeClr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AEE1B1D-7567-C848-8111-4B5B14430DBA}"/>
              </a:ext>
            </a:extLst>
          </p:cNvPr>
          <p:cNvSpPr txBox="1"/>
          <p:nvPr/>
        </p:nvSpPr>
        <p:spPr>
          <a:xfrm>
            <a:off x="1313085" y="4835429"/>
            <a:ext cx="605935" cy="27186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GAPDH</a:t>
            </a:r>
            <a:endParaRPr kumimoji="0" lang="en-US" sz="1100" b="0" i="0" u="none" strike="noStrike" cap="none" spc="0" normalizeH="0" baseline="0">
              <a:ln>
                <a:noFill/>
              </a:ln>
              <a:solidFill>
                <a:schemeClr val="tx2">
                  <a:lumMod val="50000"/>
                </a:schemeClr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F587C79-26F0-D24B-96A0-2299DD0F3CC2}"/>
              </a:ext>
            </a:extLst>
          </p:cNvPr>
          <p:cNvSpPr txBox="1"/>
          <p:nvPr/>
        </p:nvSpPr>
        <p:spPr>
          <a:xfrm>
            <a:off x="1029707" y="924668"/>
            <a:ext cx="982641" cy="27186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HIF-1</a:t>
            </a:r>
            <a:r>
              <a:rPr kumimoji="0" lang="el-GR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α</a:t>
            </a: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 (p300)</a:t>
            </a:r>
            <a:endParaRPr kumimoji="0" lang="en-US" sz="1100" b="0" i="0" u="none" strike="noStrike" cap="none" spc="0" normalizeH="0" baseline="0">
              <a:ln>
                <a:noFill/>
              </a:ln>
              <a:solidFill>
                <a:schemeClr val="tx2">
                  <a:lumMod val="50000"/>
                </a:schemeClr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DBF04CE-3726-A84B-AEE0-54245F2296B4}"/>
              </a:ext>
            </a:extLst>
          </p:cNvPr>
          <p:cNvSpPr txBox="1"/>
          <p:nvPr/>
        </p:nvSpPr>
        <p:spPr>
          <a:xfrm>
            <a:off x="1494647" y="2210719"/>
            <a:ext cx="416782" cy="27186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sz="1100">
                <a:solidFill>
                  <a:schemeClr val="tx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p</a:t>
            </a: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300</a:t>
            </a:r>
            <a:endParaRPr kumimoji="0" lang="en-US" sz="1100" b="0" i="0" u="none" strike="noStrike" cap="none" spc="0" normalizeH="0" baseline="0">
              <a:ln>
                <a:noFill/>
              </a:ln>
              <a:solidFill>
                <a:schemeClr val="tx2">
                  <a:lumMod val="50000"/>
                </a:schemeClr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1CADFE5-0517-E245-9C78-45EFB998438D}"/>
              </a:ext>
            </a:extLst>
          </p:cNvPr>
          <p:cNvSpPr txBox="1"/>
          <p:nvPr/>
        </p:nvSpPr>
        <p:spPr>
          <a:xfrm>
            <a:off x="5369205" y="4921221"/>
            <a:ext cx="6851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37 K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601368C-70D1-7541-97B0-FBA052C39E89}"/>
              </a:ext>
            </a:extLst>
          </p:cNvPr>
          <p:cNvSpPr txBox="1"/>
          <p:nvPr/>
        </p:nvSpPr>
        <p:spPr>
          <a:xfrm>
            <a:off x="5343725" y="3514226"/>
            <a:ext cx="7106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120 K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E27330-A106-9248-A4AE-B43FA331D7DF}"/>
              </a:ext>
            </a:extLst>
          </p:cNvPr>
          <p:cNvSpPr txBox="1"/>
          <p:nvPr/>
        </p:nvSpPr>
        <p:spPr>
          <a:xfrm>
            <a:off x="4193016" y="906980"/>
            <a:ext cx="7192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120 K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F1AE4D4-4DB6-E148-939D-4BA20A0221C8}"/>
              </a:ext>
            </a:extLst>
          </p:cNvPr>
          <p:cNvSpPr txBox="1"/>
          <p:nvPr/>
        </p:nvSpPr>
        <p:spPr>
          <a:xfrm>
            <a:off x="4189260" y="2262168"/>
            <a:ext cx="71921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300 K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13E1C08-B7A0-9541-B503-C05ACB722D8C}"/>
              </a:ext>
            </a:extLst>
          </p:cNvPr>
          <p:cNvSpPr txBox="1"/>
          <p:nvPr/>
        </p:nvSpPr>
        <p:spPr>
          <a:xfrm>
            <a:off x="579098" y="403351"/>
            <a:ext cx="1343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Fig 6A &amp; B</a:t>
            </a:r>
          </a:p>
        </p:txBody>
      </p:sp>
      <p:pic>
        <p:nvPicPr>
          <p:cNvPr id="23" name="Picture 22" descr="A picture containing close, blurry&#10;&#10;Description automatically generated">
            <a:extLst>
              <a:ext uri="{FF2B5EF4-FFF2-40B4-BE49-F238E27FC236}">
                <a16:creationId xmlns:a16="http://schemas.microsoft.com/office/drawing/2014/main" id="{E7ED869E-02D5-2E45-B107-DE078D72056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3100" y="6257334"/>
            <a:ext cx="1485900" cy="45720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22AFB5E0-74F5-944D-A680-5923924ECF59}"/>
              </a:ext>
            </a:extLst>
          </p:cNvPr>
          <p:cNvSpPr/>
          <p:nvPr/>
        </p:nvSpPr>
        <p:spPr>
          <a:xfrm>
            <a:off x="2194661" y="6368583"/>
            <a:ext cx="710087" cy="32540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8DEAE9D-992D-9C4D-BCA9-7F5BB8BCD5E2}"/>
              </a:ext>
            </a:extLst>
          </p:cNvPr>
          <p:cNvSpPr txBox="1"/>
          <p:nvPr/>
        </p:nvSpPr>
        <p:spPr>
          <a:xfrm>
            <a:off x="1378894" y="6380588"/>
            <a:ext cx="537006" cy="271869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HIF-1</a:t>
            </a:r>
            <a:r>
              <a:rPr kumimoji="0" lang="el-GR" altLang="zh-CN" sz="1100" b="0" i="0" u="none" strike="noStrike" cap="none" spc="0" normalizeH="0" baseline="0">
                <a:ln>
                  <a:noFill/>
                </a:ln>
                <a:solidFill>
                  <a:schemeClr val="tx2">
                    <a:lumMod val="50000"/>
                  </a:schemeClr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α</a:t>
            </a:r>
            <a:endParaRPr kumimoji="0" lang="en-US" sz="1100" b="0" i="0" u="none" strike="noStrike" cap="none" spc="0" normalizeH="0" baseline="0">
              <a:ln>
                <a:noFill/>
              </a:ln>
              <a:solidFill>
                <a:schemeClr val="tx2">
                  <a:lumMod val="50000"/>
                </a:schemeClr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3F9F725-4574-DC40-8BBD-0B1DD49126FB}"/>
              </a:ext>
            </a:extLst>
          </p:cNvPr>
          <p:cNvSpPr txBox="1"/>
          <p:nvPr/>
        </p:nvSpPr>
        <p:spPr>
          <a:xfrm>
            <a:off x="3450464" y="6355129"/>
            <a:ext cx="7106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120 K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B23B35C-65EF-2B44-BE36-7851A85B6160}"/>
              </a:ext>
            </a:extLst>
          </p:cNvPr>
          <p:cNvSpPr txBox="1"/>
          <p:nvPr/>
        </p:nvSpPr>
        <p:spPr>
          <a:xfrm>
            <a:off x="676923" y="5953407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err="1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FC49924-63DF-C647-9003-7A96D2AA97B2}"/>
              </a:ext>
            </a:extLst>
          </p:cNvPr>
          <p:cNvSpPr txBox="1"/>
          <p:nvPr/>
        </p:nvSpPr>
        <p:spPr>
          <a:xfrm>
            <a:off x="2438432" y="6723763"/>
            <a:ext cx="356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C4576A-EF70-6740-B74C-900C46E91AAF}"/>
              </a:ext>
            </a:extLst>
          </p:cNvPr>
          <p:cNvSpPr txBox="1"/>
          <p:nvPr/>
        </p:nvSpPr>
        <p:spPr>
          <a:xfrm rot="18488014">
            <a:off x="2119572" y="6114106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F89F49-DBB6-1546-95F9-9164FDCBBEE9}"/>
              </a:ext>
            </a:extLst>
          </p:cNvPr>
          <p:cNvSpPr txBox="1"/>
          <p:nvPr/>
        </p:nvSpPr>
        <p:spPr>
          <a:xfrm rot="18461405">
            <a:off x="2276038" y="6104651"/>
            <a:ext cx="4780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Bead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6F0D4ED-A76A-114F-8BE5-F95C850F4ABC}"/>
              </a:ext>
            </a:extLst>
          </p:cNvPr>
          <p:cNvSpPr txBox="1"/>
          <p:nvPr/>
        </p:nvSpPr>
        <p:spPr>
          <a:xfrm rot="18690169">
            <a:off x="2476879" y="6126338"/>
            <a:ext cx="3513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633361-CDEC-E846-AA96-198A3A250C1B}"/>
              </a:ext>
            </a:extLst>
          </p:cNvPr>
          <p:cNvSpPr txBox="1"/>
          <p:nvPr/>
        </p:nvSpPr>
        <p:spPr>
          <a:xfrm rot="18847516">
            <a:off x="2599608" y="6102182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p300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5372BD8-069D-7C4D-A680-7641335C17F8}"/>
              </a:ext>
            </a:extLst>
          </p:cNvPr>
          <p:cNvCxnSpPr>
            <a:cxnSpLocks/>
          </p:cNvCxnSpPr>
          <p:nvPr/>
        </p:nvCxnSpPr>
        <p:spPr>
          <a:xfrm>
            <a:off x="2229343" y="6764500"/>
            <a:ext cx="64072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A6737289-6883-7644-AD1E-8A42E685D1AC}"/>
              </a:ext>
            </a:extLst>
          </p:cNvPr>
          <p:cNvSpPr txBox="1"/>
          <p:nvPr/>
        </p:nvSpPr>
        <p:spPr>
          <a:xfrm rot="18572376">
            <a:off x="2257398" y="666226"/>
            <a:ext cx="33342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PB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9CC7818-5F77-D343-AF72-AD5A4EA65B55}"/>
              </a:ext>
            </a:extLst>
          </p:cNvPr>
          <p:cNvSpPr txBox="1"/>
          <p:nvPr/>
        </p:nvSpPr>
        <p:spPr>
          <a:xfrm rot="18572376">
            <a:off x="2490531" y="671118"/>
            <a:ext cx="301365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1ACCD24-00E1-6E4D-84AF-890B8DB54108}"/>
              </a:ext>
            </a:extLst>
          </p:cNvPr>
          <p:cNvSpPr txBox="1"/>
          <p:nvPr/>
        </p:nvSpPr>
        <p:spPr>
          <a:xfrm rot="18572376">
            <a:off x="2540479" y="431939"/>
            <a:ext cx="100668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</a:t>
            </a: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a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miR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-Cont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3E02BC3-CB36-474B-8209-E2A3CC7BBE96}"/>
              </a:ext>
            </a:extLst>
          </p:cNvPr>
          <p:cNvSpPr txBox="1"/>
          <p:nvPr/>
        </p:nvSpPr>
        <p:spPr>
          <a:xfrm rot="18572376">
            <a:off x="2759391" y="481773"/>
            <a:ext cx="891270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a</a:t>
            </a:r>
            <a:r>
              <a:rPr lang="en-US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miR-3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D44EC56-2CA4-F848-99FB-CC3EE50BD7C2}"/>
              </a:ext>
            </a:extLst>
          </p:cNvPr>
          <p:cNvSpPr txBox="1"/>
          <p:nvPr/>
        </p:nvSpPr>
        <p:spPr>
          <a:xfrm rot="18572376">
            <a:off x="2987463" y="567491"/>
            <a:ext cx="62837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Co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CF0308D-F17D-0447-BB70-7C96EEF2611C}"/>
              </a:ext>
            </a:extLst>
          </p:cNvPr>
          <p:cNvSpPr txBox="1"/>
          <p:nvPr/>
        </p:nvSpPr>
        <p:spPr>
          <a:xfrm rot="18572376">
            <a:off x="3167042" y="561224"/>
            <a:ext cx="634789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CEB1826-6EF1-0641-9B09-538E41E7779C}"/>
              </a:ext>
            </a:extLst>
          </p:cNvPr>
          <p:cNvSpPr txBox="1"/>
          <p:nvPr/>
        </p:nvSpPr>
        <p:spPr>
          <a:xfrm rot="18572376">
            <a:off x="3313356" y="469373"/>
            <a:ext cx="89447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Cont</a:t>
            </a:r>
            <a:endParaRPr kumimoji="0" lang="en-US" sz="9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4B33D96-48DB-A64B-99A6-8F767CBC6445}"/>
              </a:ext>
            </a:extLst>
          </p:cNvPr>
          <p:cNvSpPr txBox="1"/>
          <p:nvPr/>
        </p:nvSpPr>
        <p:spPr>
          <a:xfrm rot="18572376">
            <a:off x="3534225" y="481774"/>
            <a:ext cx="90088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8DD9E23-724A-CD40-B8B7-2108B60F3ABE}"/>
              </a:ext>
            </a:extLst>
          </p:cNvPr>
          <p:cNvSpPr txBox="1"/>
          <p:nvPr/>
        </p:nvSpPr>
        <p:spPr>
          <a:xfrm rot="18572376">
            <a:off x="2257397" y="1985904"/>
            <a:ext cx="33342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PB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9E552B2-A749-D94C-A7B0-FD724836D5DC}"/>
              </a:ext>
            </a:extLst>
          </p:cNvPr>
          <p:cNvSpPr txBox="1"/>
          <p:nvPr/>
        </p:nvSpPr>
        <p:spPr>
          <a:xfrm rot="18572376">
            <a:off x="2490530" y="1990796"/>
            <a:ext cx="301365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9BE3183-C33F-4B45-A68B-56691FE074AA}"/>
              </a:ext>
            </a:extLst>
          </p:cNvPr>
          <p:cNvSpPr txBox="1"/>
          <p:nvPr/>
        </p:nvSpPr>
        <p:spPr>
          <a:xfrm rot="18572376">
            <a:off x="2540478" y="1751617"/>
            <a:ext cx="100668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</a:t>
            </a: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a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miR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-Con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4658DF3-C739-EC47-922B-F981DAA44368}"/>
              </a:ext>
            </a:extLst>
          </p:cNvPr>
          <p:cNvSpPr txBox="1"/>
          <p:nvPr/>
        </p:nvSpPr>
        <p:spPr>
          <a:xfrm rot="18572376">
            <a:off x="2759390" y="1801451"/>
            <a:ext cx="891270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a</a:t>
            </a:r>
            <a:r>
              <a:rPr lang="en-US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miR-3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B1E4AD7-6573-6546-8A1D-47AF3AF3C8B8}"/>
              </a:ext>
            </a:extLst>
          </p:cNvPr>
          <p:cNvSpPr txBox="1"/>
          <p:nvPr/>
        </p:nvSpPr>
        <p:spPr>
          <a:xfrm rot="18572376">
            <a:off x="2987462" y="1887169"/>
            <a:ext cx="62837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Con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21C7D24-C1AE-1E4A-BEEA-23C411C7CCA0}"/>
              </a:ext>
            </a:extLst>
          </p:cNvPr>
          <p:cNvSpPr txBox="1"/>
          <p:nvPr/>
        </p:nvSpPr>
        <p:spPr>
          <a:xfrm rot="18572376">
            <a:off x="3167041" y="1880902"/>
            <a:ext cx="634789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71B9904-B5FF-FD45-85B6-57E5C529DBAC}"/>
              </a:ext>
            </a:extLst>
          </p:cNvPr>
          <p:cNvSpPr txBox="1"/>
          <p:nvPr/>
        </p:nvSpPr>
        <p:spPr>
          <a:xfrm rot="18572376">
            <a:off x="3313355" y="1789051"/>
            <a:ext cx="89447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Cont</a:t>
            </a:r>
            <a:endParaRPr kumimoji="0" lang="en-US" sz="9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5F454AE-DA89-FD49-9864-ABB417F6808B}"/>
              </a:ext>
            </a:extLst>
          </p:cNvPr>
          <p:cNvSpPr txBox="1"/>
          <p:nvPr/>
        </p:nvSpPr>
        <p:spPr>
          <a:xfrm rot="18572376">
            <a:off x="3576704" y="1809146"/>
            <a:ext cx="815928" cy="225703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8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8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8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C0E83F9-6925-F24E-9B20-6806CE7035AF}"/>
              </a:ext>
            </a:extLst>
          </p:cNvPr>
          <p:cNvSpPr txBox="1"/>
          <p:nvPr/>
        </p:nvSpPr>
        <p:spPr>
          <a:xfrm rot="18572376">
            <a:off x="2190821" y="3244983"/>
            <a:ext cx="33342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PBS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C443606-933D-2E4D-B04E-AE2298915D05}"/>
              </a:ext>
            </a:extLst>
          </p:cNvPr>
          <p:cNvSpPr txBox="1"/>
          <p:nvPr/>
        </p:nvSpPr>
        <p:spPr>
          <a:xfrm rot="18572376">
            <a:off x="2423954" y="3249875"/>
            <a:ext cx="301365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2C4EEE3-9354-CE42-9940-2558F0CA93AC}"/>
              </a:ext>
            </a:extLst>
          </p:cNvPr>
          <p:cNvSpPr txBox="1"/>
          <p:nvPr/>
        </p:nvSpPr>
        <p:spPr>
          <a:xfrm rot="18572376">
            <a:off x="2473902" y="3010696"/>
            <a:ext cx="100668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</a:t>
            </a: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a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miR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-Con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2A7076C-9DBD-5D4D-A97E-71F79100BED4}"/>
              </a:ext>
            </a:extLst>
          </p:cNvPr>
          <p:cNvSpPr txBox="1"/>
          <p:nvPr/>
        </p:nvSpPr>
        <p:spPr>
          <a:xfrm rot="18572376">
            <a:off x="2692814" y="3060530"/>
            <a:ext cx="891270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a</a:t>
            </a:r>
            <a:r>
              <a:rPr lang="en-US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miR-3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B8DDF86-B6E4-9241-884C-3FC55FCC9F6E}"/>
              </a:ext>
            </a:extLst>
          </p:cNvPr>
          <p:cNvSpPr txBox="1"/>
          <p:nvPr/>
        </p:nvSpPr>
        <p:spPr>
          <a:xfrm rot="18572376">
            <a:off x="2920886" y="3146248"/>
            <a:ext cx="62837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Cont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F6CA058-278B-4F4C-B4F2-6575A95BF894}"/>
              </a:ext>
            </a:extLst>
          </p:cNvPr>
          <p:cNvSpPr txBox="1"/>
          <p:nvPr/>
        </p:nvSpPr>
        <p:spPr>
          <a:xfrm rot="18572376">
            <a:off x="3100465" y="3139981"/>
            <a:ext cx="634789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4903076-5B99-1A49-9A09-1B0D4CCF0E46}"/>
              </a:ext>
            </a:extLst>
          </p:cNvPr>
          <p:cNvSpPr txBox="1"/>
          <p:nvPr/>
        </p:nvSpPr>
        <p:spPr>
          <a:xfrm rot="18572376">
            <a:off x="3246779" y="3048130"/>
            <a:ext cx="89447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Cont</a:t>
            </a:r>
            <a:endParaRPr kumimoji="0" lang="en-US" sz="9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9956269-28F0-8348-87F0-0E76536D628C}"/>
              </a:ext>
            </a:extLst>
          </p:cNvPr>
          <p:cNvSpPr txBox="1"/>
          <p:nvPr/>
        </p:nvSpPr>
        <p:spPr>
          <a:xfrm rot="18572376">
            <a:off x="3467648" y="3060531"/>
            <a:ext cx="90088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79513E3-7F1E-5B4C-A96F-0C04B4597142}"/>
              </a:ext>
            </a:extLst>
          </p:cNvPr>
          <p:cNvSpPr txBox="1"/>
          <p:nvPr/>
        </p:nvSpPr>
        <p:spPr>
          <a:xfrm rot="18572376">
            <a:off x="2166632" y="4574241"/>
            <a:ext cx="33342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PB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879431B-1521-1240-87D7-1DD4F73D27BD}"/>
              </a:ext>
            </a:extLst>
          </p:cNvPr>
          <p:cNvSpPr txBox="1"/>
          <p:nvPr/>
        </p:nvSpPr>
        <p:spPr>
          <a:xfrm rot="18572376">
            <a:off x="2399765" y="4579133"/>
            <a:ext cx="301365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A5CF6EC-9043-9B47-AD51-AE0B38237872}"/>
              </a:ext>
            </a:extLst>
          </p:cNvPr>
          <p:cNvSpPr txBox="1"/>
          <p:nvPr/>
        </p:nvSpPr>
        <p:spPr>
          <a:xfrm rot="18572376">
            <a:off x="2449713" y="4339954"/>
            <a:ext cx="100668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</a:t>
            </a: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a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miR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-Cont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17CC09A-6B8A-BF4C-BA8F-C1D834E7D40C}"/>
              </a:ext>
            </a:extLst>
          </p:cNvPr>
          <p:cNvSpPr txBox="1"/>
          <p:nvPr/>
        </p:nvSpPr>
        <p:spPr>
          <a:xfrm rot="18572376">
            <a:off x="2668625" y="4389788"/>
            <a:ext cx="891270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/a</a:t>
            </a:r>
            <a:r>
              <a:rPr lang="en-US" sz="9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miR-3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F619412-4148-EF4B-AB0D-0B0C0CB26A8B}"/>
              </a:ext>
            </a:extLst>
          </p:cNvPr>
          <p:cNvSpPr txBox="1"/>
          <p:nvPr/>
        </p:nvSpPr>
        <p:spPr>
          <a:xfrm rot="18572376">
            <a:off x="2896697" y="4475506"/>
            <a:ext cx="62837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Cont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CFA1953-8B83-DF46-BFE2-E04CE6C55AA1}"/>
              </a:ext>
            </a:extLst>
          </p:cNvPr>
          <p:cNvSpPr txBox="1"/>
          <p:nvPr/>
        </p:nvSpPr>
        <p:spPr>
          <a:xfrm rot="18572376">
            <a:off x="3076276" y="4469239"/>
            <a:ext cx="634789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D950016-DE24-2642-BEA8-D739725FDD3E}"/>
              </a:ext>
            </a:extLst>
          </p:cNvPr>
          <p:cNvSpPr txBox="1"/>
          <p:nvPr/>
        </p:nvSpPr>
        <p:spPr>
          <a:xfrm rot="18572376">
            <a:off x="3222590" y="4377388"/>
            <a:ext cx="894476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Cont</a:t>
            </a:r>
            <a:endParaRPr kumimoji="0" lang="en-US" sz="900" b="0" i="0" u="none" strike="noStrike" cap="none" spc="0" normalizeH="0" baseline="0">
              <a:ln>
                <a:noFill/>
              </a:ln>
              <a:solidFill>
                <a:srgbClr val="000000"/>
              </a:solidFill>
              <a:effectLst/>
              <a:uFillTx/>
              <a:latin typeface="Arial" panose="020B0604020202020204" pitchFamily="34" charset="0"/>
              <a:cs typeface="Arial" panose="020B0604020202020204" pitchFamily="34" charset="0"/>
              <a:sym typeface="Gill Sans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728D89E-56AB-1245-93B2-EB2A7D369023}"/>
              </a:ext>
            </a:extLst>
          </p:cNvPr>
          <p:cNvSpPr txBox="1"/>
          <p:nvPr/>
        </p:nvSpPr>
        <p:spPr>
          <a:xfrm rot="18572376">
            <a:off x="3443459" y="4389789"/>
            <a:ext cx="900888" cy="24109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Exo+</a:t>
            </a:r>
            <a:r>
              <a:rPr kumimoji="0" lang="en-US" sz="900" b="0" i="0" u="none" strike="noStrike" cap="none" spc="0" normalizeH="0" baseline="0" err="1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Lenti</a:t>
            </a:r>
            <a:r>
              <a:rPr kumimoji="0" lang="en-US" sz="900" b="0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Arial" panose="020B0604020202020204" pitchFamily="34" charset="0"/>
                <a:cs typeface="Arial" panose="020B0604020202020204" pitchFamily="34" charset="0"/>
                <a:sym typeface="Gill Sans"/>
              </a:rPr>
              <a:t>/FIH1</a:t>
            </a:r>
          </a:p>
        </p:txBody>
      </p:sp>
    </p:spTree>
    <p:extLst>
      <p:ext uri="{BB962C8B-B14F-4D97-AF65-F5344CB8AC3E}">
        <p14:creationId xmlns:p14="http://schemas.microsoft.com/office/powerpoint/2010/main" val="80484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83</Words>
  <Application>Microsoft Macintosh PowerPoint</Application>
  <PresentationFormat>On-screen Show (4:3)</PresentationFormat>
  <Paragraphs>10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Dong</dc:creator>
  <cp:lastModifiedBy>Zhu, Dihan</cp:lastModifiedBy>
  <cp:revision>1</cp:revision>
  <dcterms:created xsi:type="dcterms:W3CDTF">2021-02-13T21:39:34Z</dcterms:created>
  <dcterms:modified xsi:type="dcterms:W3CDTF">2021-05-09T16:19:23Z</dcterms:modified>
</cp:coreProperties>
</file>